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57" r:id="rId4"/>
    <p:sldId id="258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1044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B0572-5CC8-4C04-95DA-533F702EC6AF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45A4E-80BF-40BF-85BB-A2A05C0F149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B0572-5CC8-4C04-95DA-533F702EC6AF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45A4E-80BF-40BF-85BB-A2A05C0F149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B0572-5CC8-4C04-95DA-533F702EC6AF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45A4E-80BF-40BF-85BB-A2A05C0F149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B0572-5CC8-4C04-95DA-533F702EC6AF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45A4E-80BF-40BF-85BB-A2A05C0F149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B0572-5CC8-4C04-95DA-533F702EC6AF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45A4E-80BF-40BF-85BB-A2A05C0F149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B0572-5CC8-4C04-95DA-533F702EC6AF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45A4E-80BF-40BF-85BB-A2A05C0F149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B0572-5CC8-4C04-95DA-533F702EC6AF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45A4E-80BF-40BF-85BB-A2A05C0F149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B0572-5CC8-4C04-95DA-533F702EC6AF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45A4E-80BF-40BF-85BB-A2A05C0F149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B0572-5CC8-4C04-95DA-533F702EC6AF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45A4E-80BF-40BF-85BB-A2A05C0F149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B0572-5CC8-4C04-95DA-533F702EC6AF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45A4E-80BF-40BF-85BB-A2A05C0F149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B0572-5CC8-4C04-95DA-533F702EC6AF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45A4E-80BF-40BF-85BB-A2A05C0F149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AB0572-5CC8-4C04-95DA-533F702EC6AF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D45A4E-80BF-40BF-85BB-A2A05C0F1497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jpe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914400" y="1600200"/>
            <a:ext cx="7696200" cy="4114800"/>
            <a:chOff x="990600" y="1219200"/>
            <a:chExt cx="7696200" cy="4114800"/>
          </a:xfrm>
        </p:grpSpPr>
        <p:sp>
          <p:nvSpPr>
            <p:cNvPr id="5" name="Text Box 66"/>
            <p:cNvSpPr txBox="1">
              <a:spLocks noChangeArrowheads="1"/>
            </p:cNvSpPr>
            <p:nvPr/>
          </p:nvSpPr>
          <p:spPr bwMode="auto">
            <a:xfrm>
              <a:off x="3276600" y="2286000"/>
              <a:ext cx="1828800" cy="76200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ea typeface="Calibri" pitchFamily="34" charset="0"/>
                  <a:cs typeface="Times New Roman" pitchFamily="18" charset="0"/>
                </a:rPr>
                <a:t>3. Morphological ID of specimens</a:t>
              </a:r>
              <a:endParaRPr kumimoji="0" 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 Box 64"/>
            <p:cNvSpPr txBox="1">
              <a:spLocks noChangeArrowheads="1"/>
            </p:cNvSpPr>
            <p:nvPr/>
          </p:nvSpPr>
          <p:spPr bwMode="auto">
            <a:xfrm>
              <a:off x="1066800" y="2133600"/>
              <a:ext cx="1905000" cy="53340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ea typeface="Calibri" pitchFamily="34" charset="0"/>
                  <a:cs typeface="Times New Roman" pitchFamily="18" charset="0"/>
                </a:rPr>
                <a:t>4. Community genomic DNA extraction</a:t>
              </a:r>
              <a:endParaRPr kumimoji="0" 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Text Box 23"/>
            <p:cNvSpPr txBox="1">
              <a:spLocks noChangeArrowheads="1"/>
            </p:cNvSpPr>
            <p:nvPr/>
          </p:nvSpPr>
          <p:spPr bwMode="auto">
            <a:xfrm>
              <a:off x="7188670" y="2286000"/>
              <a:ext cx="1498130" cy="83820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ea typeface="Calibri" pitchFamily="34" charset="0"/>
                  <a:cs typeface="Times New Roman" pitchFamily="18" charset="0"/>
                </a:rPr>
                <a:t>1. Environmental Samples</a:t>
              </a:r>
              <a:endParaRPr kumimoji="0" 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Text Box 2"/>
            <p:cNvSpPr txBox="1">
              <a:spLocks noChangeArrowheads="1"/>
            </p:cNvSpPr>
            <p:nvPr/>
          </p:nvSpPr>
          <p:spPr bwMode="auto">
            <a:xfrm>
              <a:off x="5105400" y="2209800"/>
              <a:ext cx="1905000" cy="83820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ea typeface="Calibri" pitchFamily="34" charset="0"/>
                  <a:cs typeface="Times New Roman" pitchFamily="18" charset="0"/>
                </a:rPr>
                <a:t>2. Individual specimens (~10-100 per sample)</a:t>
              </a:r>
              <a:endParaRPr kumimoji="0" 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" name="Left Arrow 50"/>
            <p:cNvSpPr/>
            <p:nvPr/>
          </p:nvSpPr>
          <p:spPr>
            <a:xfrm>
              <a:off x="4724400" y="1676400"/>
              <a:ext cx="526251" cy="233889"/>
            </a:xfrm>
            <a:prstGeom prst="lef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Left Arrow 51"/>
            <p:cNvSpPr/>
            <p:nvPr/>
          </p:nvSpPr>
          <p:spPr>
            <a:xfrm>
              <a:off x="3048000" y="1676400"/>
              <a:ext cx="526251" cy="233889"/>
            </a:xfrm>
            <a:prstGeom prst="lef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53" name="Picture 8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3886200" y="1371600"/>
              <a:ext cx="701668" cy="7016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54" name="Picture 83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752600" y="1447800"/>
              <a:ext cx="701668" cy="7016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55" name="Picture 4"/>
            <p:cNvPicPr>
              <a:picLocks noChangeAspect="1" noChangeArrowheads="1"/>
            </p:cNvPicPr>
            <p:nvPr/>
          </p:nvPicPr>
          <p:blipFill>
            <a:blip r:embed="rId4" cstate="print"/>
            <a:srcRect l="17143" t="8858" b="5429"/>
            <a:stretch>
              <a:fillRect/>
            </a:stretch>
          </p:blipFill>
          <p:spPr bwMode="auto">
            <a:xfrm>
              <a:off x="990600" y="3442816"/>
              <a:ext cx="1988060" cy="12853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56" name="Picture 2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1107545" y="4378374"/>
              <a:ext cx="1739553" cy="4093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58" name="Group 138"/>
            <p:cNvGrpSpPr/>
            <p:nvPr/>
          </p:nvGrpSpPr>
          <p:grpSpPr>
            <a:xfrm>
              <a:off x="3154077" y="3501288"/>
              <a:ext cx="409307" cy="75179"/>
              <a:chOff x="4876800" y="31470600"/>
              <a:chExt cx="533400" cy="97972"/>
            </a:xfrm>
          </p:grpSpPr>
          <p:sp>
            <p:nvSpPr>
              <p:cNvPr id="151" name="Pentagon 150"/>
              <p:cNvSpPr/>
              <p:nvPr/>
            </p:nvSpPr>
            <p:spPr>
              <a:xfrm>
                <a:off x="4953000" y="31470600"/>
                <a:ext cx="457200" cy="97971"/>
              </a:xfrm>
              <a:prstGeom prst="homePlate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2" name="Rectangle 151"/>
              <p:cNvSpPr/>
              <p:nvPr/>
            </p:nvSpPr>
            <p:spPr>
              <a:xfrm>
                <a:off x="4876800" y="31470600"/>
                <a:ext cx="81643" cy="97972"/>
              </a:xfrm>
              <a:prstGeom prst="rect">
                <a:avLst/>
              </a:prstGeom>
              <a:solidFill>
                <a:schemeClr val="accent2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59" name="Group 139"/>
            <p:cNvGrpSpPr/>
            <p:nvPr/>
          </p:nvGrpSpPr>
          <p:grpSpPr>
            <a:xfrm>
              <a:off x="3154077" y="3735178"/>
              <a:ext cx="409307" cy="75179"/>
              <a:chOff x="5029200" y="31623000"/>
              <a:chExt cx="533400" cy="97972"/>
            </a:xfrm>
          </p:grpSpPr>
          <p:sp>
            <p:nvSpPr>
              <p:cNvPr id="149" name="Pentagon 148"/>
              <p:cNvSpPr/>
              <p:nvPr/>
            </p:nvSpPr>
            <p:spPr>
              <a:xfrm>
                <a:off x="5105400" y="31623000"/>
                <a:ext cx="457200" cy="97971"/>
              </a:xfrm>
              <a:prstGeom prst="homePlate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0" name="Rectangle 149"/>
              <p:cNvSpPr/>
              <p:nvPr/>
            </p:nvSpPr>
            <p:spPr>
              <a:xfrm>
                <a:off x="5029200" y="31623000"/>
                <a:ext cx="81643" cy="97972"/>
              </a:xfrm>
              <a:prstGeom prst="rect">
                <a:avLst/>
              </a:prstGeom>
              <a:solidFill>
                <a:schemeClr val="accent4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0" name="Group 140"/>
            <p:cNvGrpSpPr/>
            <p:nvPr/>
          </p:nvGrpSpPr>
          <p:grpSpPr>
            <a:xfrm>
              <a:off x="3621856" y="4086012"/>
              <a:ext cx="409307" cy="75179"/>
              <a:chOff x="5181600" y="31775400"/>
              <a:chExt cx="533400" cy="97972"/>
            </a:xfrm>
          </p:grpSpPr>
          <p:sp>
            <p:nvSpPr>
              <p:cNvPr id="147" name="Pentagon 146"/>
              <p:cNvSpPr/>
              <p:nvPr/>
            </p:nvSpPr>
            <p:spPr>
              <a:xfrm>
                <a:off x="5257800" y="31775400"/>
                <a:ext cx="457200" cy="97971"/>
              </a:xfrm>
              <a:prstGeom prst="homePlate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8" name="Rectangle 147"/>
              <p:cNvSpPr/>
              <p:nvPr/>
            </p:nvSpPr>
            <p:spPr>
              <a:xfrm>
                <a:off x="5181600" y="31775400"/>
                <a:ext cx="81643" cy="97972"/>
              </a:xfrm>
              <a:prstGeom prst="rect">
                <a:avLst/>
              </a:prstGeom>
              <a:solidFill>
                <a:schemeClr val="accent3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1" name="Group 141"/>
            <p:cNvGrpSpPr/>
            <p:nvPr/>
          </p:nvGrpSpPr>
          <p:grpSpPr>
            <a:xfrm>
              <a:off x="4031163" y="3735178"/>
              <a:ext cx="409307" cy="75179"/>
              <a:chOff x="5334000" y="31927800"/>
              <a:chExt cx="533400" cy="97972"/>
            </a:xfrm>
          </p:grpSpPr>
          <p:sp>
            <p:nvSpPr>
              <p:cNvPr id="145" name="Pentagon 144"/>
              <p:cNvSpPr/>
              <p:nvPr/>
            </p:nvSpPr>
            <p:spPr>
              <a:xfrm>
                <a:off x="5410200" y="31927800"/>
                <a:ext cx="457200" cy="97971"/>
              </a:xfrm>
              <a:prstGeom prst="homePlate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6" name="Rectangle 145"/>
              <p:cNvSpPr/>
              <p:nvPr/>
            </p:nvSpPr>
            <p:spPr>
              <a:xfrm>
                <a:off x="5334000" y="31927800"/>
                <a:ext cx="81643" cy="97972"/>
              </a:xfrm>
              <a:prstGeom prst="rect">
                <a:avLst/>
              </a:prstGeom>
              <a:solidFill>
                <a:schemeClr val="accent2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2" name="Group 142"/>
            <p:cNvGrpSpPr/>
            <p:nvPr/>
          </p:nvGrpSpPr>
          <p:grpSpPr>
            <a:xfrm>
              <a:off x="4031163" y="3501288"/>
              <a:ext cx="409307" cy="75179"/>
              <a:chOff x="5486400" y="32080200"/>
              <a:chExt cx="533400" cy="97972"/>
            </a:xfrm>
          </p:grpSpPr>
          <p:sp>
            <p:nvSpPr>
              <p:cNvPr id="143" name="Pentagon 142"/>
              <p:cNvSpPr/>
              <p:nvPr/>
            </p:nvSpPr>
            <p:spPr>
              <a:xfrm>
                <a:off x="5562600" y="32080200"/>
                <a:ext cx="457200" cy="97971"/>
              </a:xfrm>
              <a:prstGeom prst="homePlate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4" name="Rectangle 143"/>
              <p:cNvSpPr/>
              <p:nvPr/>
            </p:nvSpPr>
            <p:spPr>
              <a:xfrm>
                <a:off x="5486400" y="32080200"/>
                <a:ext cx="81643" cy="97972"/>
              </a:xfrm>
              <a:prstGeom prst="rect">
                <a:avLst/>
              </a:prstGeom>
              <a:solidFill>
                <a:schemeClr val="accent4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3" name="Group 137"/>
            <p:cNvGrpSpPr/>
            <p:nvPr/>
          </p:nvGrpSpPr>
          <p:grpSpPr>
            <a:xfrm>
              <a:off x="4031163" y="3969067"/>
              <a:ext cx="409307" cy="75179"/>
              <a:chOff x="2514600" y="32080200"/>
              <a:chExt cx="533400" cy="97972"/>
            </a:xfrm>
          </p:grpSpPr>
          <p:sp>
            <p:nvSpPr>
              <p:cNvPr id="141" name="Pentagon 140"/>
              <p:cNvSpPr/>
              <p:nvPr/>
            </p:nvSpPr>
            <p:spPr>
              <a:xfrm>
                <a:off x="2590800" y="32080200"/>
                <a:ext cx="457200" cy="97971"/>
              </a:xfrm>
              <a:prstGeom prst="homePlate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2" name="Rectangle 141"/>
              <p:cNvSpPr/>
              <p:nvPr/>
            </p:nvSpPr>
            <p:spPr>
              <a:xfrm>
                <a:off x="2514600" y="32080200"/>
                <a:ext cx="81643" cy="97972"/>
              </a:xfrm>
              <a:prstGeom prst="rect">
                <a:avLst/>
              </a:prstGeom>
              <a:solidFill>
                <a:schemeClr val="accent4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4" name="Group 143"/>
            <p:cNvGrpSpPr/>
            <p:nvPr/>
          </p:nvGrpSpPr>
          <p:grpSpPr>
            <a:xfrm>
              <a:off x="3154077" y="4202956"/>
              <a:ext cx="409307" cy="75179"/>
              <a:chOff x="6096000" y="31470600"/>
              <a:chExt cx="533400" cy="97972"/>
            </a:xfrm>
          </p:grpSpPr>
          <p:sp>
            <p:nvSpPr>
              <p:cNvPr id="139" name="Pentagon 138"/>
              <p:cNvSpPr/>
              <p:nvPr/>
            </p:nvSpPr>
            <p:spPr>
              <a:xfrm>
                <a:off x="6172200" y="31470600"/>
                <a:ext cx="457200" cy="97971"/>
              </a:xfrm>
              <a:prstGeom prst="homePlate">
                <a:avLst/>
              </a:prstGeom>
              <a:solidFill>
                <a:schemeClr val="accent4">
                  <a:lumMod val="40000"/>
                  <a:lumOff val="6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0" name="Rectangle 139"/>
              <p:cNvSpPr/>
              <p:nvPr/>
            </p:nvSpPr>
            <p:spPr>
              <a:xfrm>
                <a:off x="6096000" y="31470600"/>
                <a:ext cx="81643" cy="97972"/>
              </a:xfrm>
              <a:prstGeom prst="rect">
                <a:avLst/>
              </a:prstGeom>
              <a:solidFill>
                <a:schemeClr val="accent2">
                  <a:lumMod val="75000"/>
                </a:schemeClr>
              </a:solidFill>
              <a:ln w="6350">
                <a:solidFill>
                  <a:schemeClr val="accent4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5" name="Group 144"/>
            <p:cNvGrpSpPr/>
            <p:nvPr/>
          </p:nvGrpSpPr>
          <p:grpSpPr>
            <a:xfrm>
              <a:off x="3621856" y="4319901"/>
              <a:ext cx="409307" cy="75179"/>
              <a:chOff x="6248400" y="31623000"/>
              <a:chExt cx="533400" cy="97972"/>
            </a:xfrm>
          </p:grpSpPr>
          <p:sp>
            <p:nvSpPr>
              <p:cNvPr id="137" name="Pentagon 136"/>
              <p:cNvSpPr/>
              <p:nvPr/>
            </p:nvSpPr>
            <p:spPr>
              <a:xfrm>
                <a:off x="6324600" y="31623000"/>
                <a:ext cx="457200" cy="97971"/>
              </a:xfrm>
              <a:prstGeom prst="homePlat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8" name="Rectangle 137"/>
              <p:cNvSpPr/>
              <p:nvPr/>
            </p:nvSpPr>
            <p:spPr>
              <a:xfrm>
                <a:off x="6248400" y="31623000"/>
                <a:ext cx="81643" cy="97972"/>
              </a:xfrm>
              <a:prstGeom prst="rect">
                <a:avLst/>
              </a:prstGeom>
              <a:solidFill>
                <a:schemeClr val="accent3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6" name="Group 145"/>
            <p:cNvGrpSpPr/>
            <p:nvPr/>
          </p:nvGrpSpPr>
          <p:grpSpPr>
            <a:xfrm>
              <a:off x="3154077" y="3969067"/>
              <a:ext cx="409307" cy="75179"/>
              <a:chOff x="6400800" y="31775400"/>
              <a:chExt cx="533400" cy="97972"/>
            </a:xfrm>
          </p:grpSpPr>
          <p:sp>
            <p:nvSpPr>
              <p:cNvPr id="135" name="Pentagon 134"/>
              <p:cNvSpPr/>
              <p:nvPr/>
            </p:nvSpPr>
            <p:spPr>
              <a:xfrm>
                <a:off x="6477000" y="31775400"/>
                <a:ext cx="457200" cy="97971"/>
              </a:xfrm>
              <a:prstGeom prst="homePlat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6" name="Rectangle 135"/>
              <p:cNvSpPr/>
              <p:nvPr/>
            </p:nvSpPr>
            <p:spPr>
              <a:xfrm>
                <a:off x="6400800" y="31775400"/>
                <a:ext cx="81643" cy="97972"/>
              </a:xfrm>
              <a:prstGeom prst="rect">
                <a:avLst/>
              </a:prstGeom>
              <a:solidFill>
                <a:schemeClr val="accent2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7" name="Group 136"/>
            <p:cNvGrpSpPr/>
            <p:nvPr/>
          </p:nvGrpSpPr>
          <p:grpSpPr>
            <a:xfrm>
              <a:off x="3621856" y="3852122"/>
              <a:ext cx="409307" cy="75179"/>
              <a:chOff x="6248400" y="32080200"/>
              <a:chExt cx="533400" cy="97972"/>
            </a:xfrm>
          </p:grpSpPr>
          <p:sp>
            <p:nvSpPr>
              <p:cNvPr id="133" name="Pentagon 132"/>
              <p:cNvSpPr/>
              <p:nvPr/>
            </p:nvSpPr>
            <p:spPr>
              <a:xfrm>
                <a:off x="6324600" y="32080200"/>
                <a:ext cx="457200" cy="97971"/>
              </a:xfrm>
              <a:prstGeom prst="homePlate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4" name="Rectangle 133"/>
              <p:cNvSpPr/>
              <p:nvPr/>
            </p:nvSpPr>
            <p:spPr>
              <a:xfrm>
                <a:off x="6248400" y="32080200"/>
                <a:ext cx="81643" cy="97972"/>
              </a:xfrm>
              <a:prstGeom prst="rect">
                <a:avLst/>
              </a:prstGeom>
              <a:solidFill>
                <a:schemeClr val="accent2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8" name="Group 146"/>
            <p:cNvGrpSpPr/>
            <p:nvPr/>
          </p:nvGrpSpPr>
          <p:grpSpPr>
            <a:xfrm>
              <a:off x="4031163" y="4202956"/>
              <a:ext cx="409307" cy="75179"/>
              <a:chOff x="6400800" y="32232600"/>
              <a:chExt cx="533400" cy="97972"/>
            </a:xfrm>
          </p:grpSpPr>
          <p:sp>
            <p:nvSpPr>
              <p:cNvPr id="131" name="Pentagon 130"/>
              <p:cNvSpPr/>
              <p:nvPr/>
            </p:nvSpPr>
            <p:spPr>
              <a:xfrm>
                <a:off x="6477000" y="32232600"/>
                <a:ext cx="457200" cy="97971"/>
              </a:xfrm>
              <a:prstGeom prst="homePlate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2" name="Rectangle 131"/>
              <p:cNvSpPr/>
              <p:nvPr/>
            </p:nvSpPr>
            <p:spPr>
              <a:xfrm>
                <a:off x="6400800" y="32232600"/>
                <a:ext cx="81643" cy="97972"/>
              </a:xfrm>
              <a:prstGeom prst="rect">
                <a:avLst/>
              </a:prstGeom>
              <a:solidFill>
                <a:schemeClr val="accent3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9" name="Group 147"/>
            <p:cNvGrpSpPr/>
            <p:nvPr/>
          </p:nvGrpSpPr>
          <p:grpSpPr>
            <a:xfrm>
              <a:off x="3621856" y="3618233"/>
              <a:ext cx="409307" cy="75179"/>
              <a:chOff x="6553200" y="32385000"/>
              <a:chExt cx="533400" cy="97972"/>
            </a:xfrm>
          </p:grpSpPr>
          <p:sp>
            <p:nvSpPr>
              <p:cNvPr id="129" name="Pentagon 128"/>
              <p:cNvSpPr/>
              <p:nvPr/>
            </p:nvSpPr>
            <p:spPr>
              <a:xfrm>
                <a:off x="6629400" y="32385000"/>
                <a:ext cx="457200" cy="97971"/>
              </a:xfrm>
              <a:prstGeom prst="homePlate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0" name="Rectangle 129"/>
              <p:cNvSpPr/>
              <p:nvPr/>
            </p:nvSpPr>
            <p:spPr>
              <a:xfrm>
                <a:off x="6553200" y="32385000"/>
                <a:ext cx="81643" cy="97972"/>
              </a:xfrm>
              <a:prstGeom prst="rect">
                <a:avLst/>
              </a:prstGeom>
              <a:solidFill>
                <a:schemeClr val="accent3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70" name="Group 141"/>
            <p:cNvGrpSpPr/>
            <p:nvPr/>
          </p:nvGrpSpPr>
          <p:grpSpPr>
            <a:xfrm>
              <a:off x="3972690" y="4495318"/>
              <a:ext cx="409307" cy="75179"/>
              <a:chOff x="5334000" y="31927800"/>
              <a:chExt cx="533400" cy="97972"/>
            </a:xfrm>
          </p:grpSpPr>
          <p:sp>
            <p:nvSpPr>
              <p:cNvPr id="127" name="Pentagon 126"/>
              <p:cNvSpPr/>
              <p:nvPr/>
            </p:nvSpPr>
            <p:spPr>
              <a:xfrm>
                <a:off x="5410200" y="31927800"/>
                <a:ext cx="457200" cy="97971"/>
              </a:xfrm>
              <a:prstGeom prst="homePlate">
                <a:avLst/>
              </a:prstGeom>
              <a:gradFill flip="none" rotWithShape="1">
                <a:gsLst>
                  <a:gs pos="0">
                    <a:schemeClr val="accent4">
                      <a:lumMod val="60000"/>
                      <a:lumOff val="40000"/>
                    </a:schemeClr>
                  </a:gs>
                  <a:gs pos="100000">
                    <a:schemeClr val="accent3">
                      <a:lumMod val="60000"/>
                      <a:lumOff val="40000"/>
                    </a:schemeClr>
                  </a:gs>
                  <a:gs pos="100000">
                    <a:schemeClr val="accent1">
                      <a:tint val="23500"/>
                      <a:satMod val="160000"/>
                    </a:schemeClr>
                  </a:gs>
                </a:gsLst>
                <a:lin ang="0" scaled="1"/>
                <a:tileRect/>
              </a:gra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8" name="Rectangle 127"/>
              <p:cNvSpPr/>
              <p:nvPr/>
            </p:nvSpPr>
            <p:spPr>
              <a:xfrm>
                <a:off x="5334000" y="31927800"/>
                <a:ext cx="81643" cy="97972"/>
              </a:xfrm>
              <a:prstGeom prst="rect">
                <a:avLst/>
              </a:prstGeom>
              <a:solidFill>
                <a:schemeClr val="accent2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71" name="Group 137"/>
            <p:cNvGrpSpPr/>
            <p:nvPr/>
          </p:nvGrpSpPr>
          <p:grpSpPr>
            <a:xfrm>
              <a:off x="3271022" y="4495318"/>
              <a:ext cx="409307" cy="75179"/>
              <a:chOff x="2514600" y="32080200"/>
              <a:chExt cx="533400" cy="97972"/>
            </a:xfrm>
          </p:grpSpPr>
          <p:sp>
            <p:nvSpPr>
              <p:cNvPr id="125" name="Pentagon 124"/>
              <p:cNvSpPr/>
              <p:nvPr/>
            </p:nvSpPr>
            <p:spPr>
              <a:xfrm>
                <a:off x="2590800" y="32080200"/>
                <a:ext cx="457200" cy="97971"/>
              </a:xfrm>
              <a:prstGeom prst="homePlate">
                <a:avLst/>
              </a:prstGeom>
              <a:gradFill flip="none" rotWithShape="1">
                <a:gsLst>
                  <a:gs pos="0">
                    <a:schemeClr val="accent6">
                      <a:lumMod val="60000"/>
                      <a:lumOff val="40000"/>
                    </a:schemeClr>
                  </a:gs>
                  <a:gs pos="100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1">
                      <a:tint val="23500"/>
                      <a:satMod val="160000"/>
                    </a:schemeClr>
                  </a:gs>
                </a:gsLst>
                <a:lin ang="0" scaled="1"/>
                <a:tileRect/>
              </a:gra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6" name="Rectangle 125"/>
              <p:cNvSpPr/>
              <p:nvPr/>
            </p:nvSpPr>
            <p:spPr>
              <a:xfrm>
                <a:off x="2514600" y="32080200"/>
                <a:ext cx="81643" cy="97972"/>
              </a:xfrm>
              <a:prstGeom prst="rect">
                <a:avLst/>
              </a:prstGeom>
              <a:solidFill>
                <a:schemeClr val="accent4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72" name="Group 145"/>
            <p:cNvGrpSpPr/>
            <p:nvPr/>
          </p:nvGrpSpPr>
          <p:grpSpPr>
            <a:xfrm>
              <a:off x="3563384" y="4670735"/>
              <a:ext cx="409307" cy="75179"/>
              <a:chOff x="6400800" y="31775400"/>
              <a:chExt cx="533400" cy="97972"/>
            </a:xfrm>
          </p:grpSpPr>
          <p:sp>
            <p:nvSpPr>
              <p:cNvPr id="123" name="Pentagon 122"/>
              <p:cNvSpPr/>
              <p:nvPr/>
            </p:nvSpPr>
            <p:spPr>
              <a:xfrm>
                <a:off x="6477000" y="31775400"/>
                <a:ext cx="457200" cy="97971"/>
              </a:xfrm>
              <a:prstGeom prst="homePlate">
                <a:avLst/>
              </a:prstGeom>
              <a:gradFill flip="none" rotWithShape="1">
                <a:gsLst>
                  <a:gs pos="0">
                    <a:schemeClr val="accent5">
                      <a:lumMod val="60000"/>
                      <a:lumOff val="40000"/>
                    </a:schemeClr>
                  </a:gs>
                  <a:gs pos="100000">
                    <a:schemeClr val="accent6">
                      <a:lumMod val="60000"/>
                      <a:lumOff val="40000"/>
                    </a:schemeClr>
                  </a:gs>
                  <a:gs pos="100000">
                    <a:schemeClr val="accent1">
                      <a:tint val="23500"/>
                      <a:satMod val="160000"/>
                    </a:schemeClr>
                  </a:gs>
                </a:gsLst>
                <a:lin ang="0" scaled="1"/>
                <a:tileRect/>
              </a:gra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4" name="Rectangle 123"/>
              <p:cNvSpPr/>
              <p:nvPr/>
            </p:nvSpPr>
            <p:spPr>
              <a:xfrm>
                <a:off x="6400800" y="31775400"/>
                <a:ext cx="81643" cy="97972"/>
              </a:xfrm>
              <a:prstGeom prst="rect">
                <a:avLst/>
              </a:prstGeom>
              <a:solidFill>
                <a:schemeClr val="accent2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73" name="Right Arrow 72"/>
            <p:cNvSpPr/>
            <p:nvPr/>
          </p:nvSpPr>
          <p:spPr>
            <a:xfrm>
              <a:off x="4615886" y="3442816"/>
              <a:ext cx="1286392" cy="1169447"/>
            </a:xfrm>
            <a:prstGeom prst="rightArrow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>
                  <a:solidFill>
                    <a:schemeClr val="tx1"/>
                  </a:solidFill>
                </a:rPr>
                <a:t>7. Quality filtering</a:t>
              </a:r>
            </a:p>
          </p:txBody>
        </p:sp>
        <p:grpSp>
          <p:nvGrpSpPr>
            <p:cNvPr id="74" name="Group 321"/>
            <p:cNvGrpSpPr/>
            <p:nvPr/>
          </p:nvGrpSpPr>
          <p:grpSpPr>
            <a:xfrm>
              <a:off x="6019223" y="3325871"/>
              <a:ext cx="2513042" cy="1069209"/>
              <a:chOff x="7162800" y="29260800"/>
              <a:chExt cx="3274946" cy="1393372"/>
            </a:xfrm>
          </p:grpSpPr>
          <p:grpSp>
            <p:nvGrpSpPr>
              <p:cNvPr id="75" name="Group 138"/>
              <p:cNvGrpSpPr/>
              <p:nvPr/>
            </p:nvGrpSpPr>
            <p:grpSpPr>
              <a:xfrm>
                <a:off x="9780713" y="30251400"/>
                <a:ext cx="533400" cy="97972"/>
                <a:chOff x="4876800" y="31470600"/>
                <a:chExt cx="533400" cy="97972"/>
              </a:xfrm>
            </p:grpSpPr>
            <p:sp>
              <p:nvSpPr>
                <p:cNvPr id="121" name="Pentagon 120"/>
                <p:cNvSpPr/>
                <p:nvPr/>
              </p:nvSpPr>
              <p:spPr>
                <a:xfrm>
                  <a:off x="4953000" y="31470600"/>
                  <a:ext cx="457200" cy="97971"/>
                </a:xfrm>
                <a:prstGeom prst="homePlate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2" name="Rectangle 121"/>
                <p:cNvSpPr/>
                <p:nvPr/>
              </p:nvSpPr>
              <p:spPr>
                <a:xfrm>
                  <a:off x="4876800" y="31470600"/>
                  <a:ext cx="81643" cy="97972"/>
                </a:xfrm>
                <a:prstGeom prst="rect">
                  <a:avLst/>
                </a:prstGeom>
                <a:solidFill>
                  <a:schemeClr val="accent2">
                    <a:lumMod val="7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76" name="Group 139"/>
              <p:cNvGrpSpPr/>
              <p:nvPr/>
            </p:nvGrpSpPr>
            <p:grpSpPr>
              <a:xfrm>
                <a:off x="8382000" y="29946600"/>
                <a:ext cx="533400" cy="97972"/>
                <a:chOff x="5029200" y="31623000"/>
                <a:chExt cx="533400" cy="97972"/>
              </a:xfrm>
            </p:grpSpPr>
            <p:sp>
              <p:nvSpPr>
                <p:cNvPr id="119" name="Pentagon 118"/>
                <p:cNvSpPr/>
                <p:nvPr/>
              </p:nvSpPr>
              <p:spPr>
                <a:xfrm>
                  <a:off x="5105400" y="31623000"/>
                  <a:ext cx="457200" cy="97971"/>
                </a:xfrm>
                <a:prstGeom prst="homePlate">
                  <a:avLst/>
                </a:prstGeom>
                <a:solidFill>
                  <a:schemeClr val="accent3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0" name="Rectangle 119"/>
                <p:cNvSpPr/>
                <p:nvPr/>
              </p:nvSpPr>
              <p:spPr>
                <a:xfrm>
                  <a:off x="5029200" y="31623000"/>
                  <a:ext cx="81643" cy="97972"/>
                </a:xfrm>
                <a:prstGeom prst="rect">
                  <a:avLst/>
                </a:prstGeom>
                <a:solidFill>
                  <a:schemeClr val="accent4">
                    <a:lumMod val="7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77" name="Group 140"/>
              <p:cNvGrpSpPr/>
              <p:nvPr/>
            </p:nvGrpSpPr>
            <p:grpSpPr>
              <a:xfrm>
                <a:off x="9094913" y="30251400"/>
                <a:ext cx="533400" cy="97972"/>
                <a:chOff x="5181600" y="31775400"/>
                <a:chExt cx="533400" cy="97972"/>
              </a:xfrm>
            </p:grpSpPr>
            <p:sp>
              <p:nvSpPr>
                <p:cNvPr id="117" name="Pentagon 116"/>
                <p:cNvSpPr/>
                <p:nvPr/>
              </p:nvSpPr>
              <p:spPr>
                <a:xfrm>
                  <a:off x="5257800" y="31775400"/>
                  <a:ext cx="457200" cy="97971"/>
                </a:xfrm>
                <a:prstGeom prst="homePlate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8" name="Rectangle 117"/>
                <p:cNvSpPr/>
                <p:nvPr/>
              </p:nvSpPr>
              <p:spPr>
                <a:xfrm>
                  <a:off x="5181600" y="31775400"/>
                  <a:ext cx="81643" cy="97972"/>
                </a:xfrm>
                <a:prstGeom prst="rect">
                  <a:avLst/>
                </a:prstGeom>
                <a:solidFill>
                  <a:schemeClr val="accent3">
                    <a:lumMod val="7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78" name="Group 141"/>
              <p:cNvGrpSpPr/>
              <p:nvPr/>
            </p:nvGrpSpPr>
            <p:grpSpPr>
              <a:xfrm>
                <a:off x="9780713" y="29946600"/>
                <a:ext cx="533400" cy="97972"/>
                <a:chOff x="5334000" y="31927800"/>
                <a:chExt cx="533400" cy="97972"/>
              </a:xfrm>
            </p:grpSpPr>
            <p:sp>
              <p:nvSpPr>
                <p:cNvPr id="115" name="Pentagon 114"/>
                <p:cNvSpPr/>
                <p:nvPr/>
              </p:nvSpPr>
              <p:spPr>
                <a:xfrm>
                  <a:off x="5410200" y="31927800"/>
                  <a:ext cx="457200" cy="97971"/>
                </a:xfrm>
                <a:prstGeom prst="homePlate">
                  <a:avLst/>
                </a:prstGeom>
                <a:solidFill>
                  <a:schemeClr val="accent3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6" name="Rectangle 115"/>
                <p:cNvSpPr/>
                <p:nvPr/>
              </p:nvSpPr>
              <p:spPr>
                <a:xfrm>
                  <a:off x="5334000" y="31927800"/>
                  <a:ext cx="81643" cy="97972"/>
                </a:xfrm>
                <a:prstGeom prst="rect">
                  <a:avLst/>
                </a:prstGeom>
                <a:solidFill>
                  <a:schemeClr val="accent2">
                    <a:lumMod val="7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79" name="Group 142"/>
              <p:cNvGrpSpPr/>
              <p:nvPr/>
            </p:nvGrpSpPr>
            <p:grpSpPr>
              <a:xfrm>
                <a:off x="8382000" y="30251400"/>
                <a:ext cx="533400" cy="97972"/>
                <a:chOff x="5486400" y="32080200"/>
                <a:chExt cx="533400" cy="97972"/>
              </a:xfrm>
            </p:grpSpPr>
            <p:sp>
              <p:nvSpPr>
                <p:cNvPr id="113" name="Pentagon 112"/>
                <p:cNvSpPr/>
                <p:nvPr/>
              </p:nvSpPr>
              <p:spPr>
                <a:xfrm>
                  <a:off x="5562600" y="32080200"/>
                  <a:ext cx="457200" cy="97971"/>
                </a:xfrm>
                <a:prstGeom prst="homePlate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4" name="Rectangle 113"/>
                <p:cNvSpPr/>
                <p:nvPr/>
              </p:nvSpPr>
              <p:spPr>
                <a:xfrm>
                  <a:off x="5486400" y="32080200"/>
                  <a:ext cx="81643" cy="97972"/>
                </a:xfrm>
                <a:prstGeom prst="rect">
                  <a:avLst/>
                </a:prstGeom>
                <a:solidFill>
                  <a:schemeClr val="accent4">
                    <a:lumMod val="7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80" name="Group 137"/>
              <p:cNvGrpSpPr/>
              <p:nvPr/>
            </p:nvGrpSpPr>
            <p:grpSpPr>
              <a:xfrm>
                <a:off x="8382000" y="29641800"/>
                <a:ext cx="533400" cy="97972"/>
                <a:chOff x="2514600" y="32080200"/>
                <a:chExt cx="533400" cy="97972"/>
              </a:xfrm>
            </p:grpSpPr>
            <p:sp>
              <p:nvSpPr>
                <p:cNvPr id="111" name="Pentagon 110"/>
                <p:cNvSpPr/>
                <p:nvPr/>
              </p:nvSpPr>
              <p:spPr>
                <a:xfrm>
                  <a:off x="2590800" y="32080200"/>
                  <a:ext cx="457200" cy="97971"/>
                </a:xfrm>
                <a:prstGeom prst="homePlate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2" name="Rectangle 111"/>
                <p:cNvSpPr/>
                <p:nvPr/>
              </p:nvSpPr>
              <p:spPr>
                <a:xfrm>
                  <a:off x="2514600" y="32080200"/>
                  <a:ext cx="81643" cy="97972"/>
                </a:xfrm>
                <a:prstGeom prst="rect">
                  <a:avLst/>
                </a:prstGeom>
                <a:solidFill>
                  <a:schemeClr val="accent4">
                    <a:lumMod val="7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81" name="Group 143"/>
              <p:cNvGrpSpPr/>
              <p:nvPr/>
            </p:nvGrpSpPr>
            <p:grpSpPr>
              <a:xfrm>
                <a:off x="8382000" y="30556200"/>
                <a:ext cx="533400" cy="97972"/>
                <a:chOff x="6096000" y="31470600"/>
                <a:chExt cx="533400" cy="97972"/>
              </a:xfrm>
            </p:grpSpPr>
            <p:sp>
              <p:nvSpPr>
                <p:cNvPr id="109" name="Pentagon 108"/>
                <p:cNvSpPr/>
                <p:nvPr/>
              </p:nvSpPr>
              <p:spPr>
                <a:xfrm>
                  <a:off x="6172200" y="31470600"/>
                  <a:ext cx="457200" cy="97971"/>
                </a:xfrm>
                <a:prstGeom prst="homePlate">
                  <a:avLst/>
                </a:prstGeom>
                <a:solidFill>
                  <a:schemeClr val="accent4">
                    <a:lumMod val="40000"/>
                    <a:lumOff val="6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0" name="Rectangle 109"/>
                <p:cNvSpPr/>
                <p:nvPr/>
              </p:nvSpPr>
              <p:spPr>
                <a:xfrm>
                  <a:off x="6096000" y="31470600"/>
                  <a:ext cx="81643" cy="97972"/>
                </a:xfrm>
                <a:prstGeom prst="rect">
                  <a:avLst/>
                </a:prstGeom>
                <a:solidFill>
                  <a:schemeClr val="accent2">
                    <a:lumMod val="75000"/>
                  </a:schemeClr>
                </a:solidFill>
                <a:ln w="6350">
                  <a:solidFill>
                    <a:schemeClr val="accent4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82" name="Group 144"/>
              <p:cNvGrpSpPr/>
              <p:nvPr/>
            </p:nvGrpSpPr>
            <p:grpSpPr>
              <a:xfrm>
                <a:off x="9094913" y="30556200"/>
                <a:ext cx="533400" cy="97972"/>
                <a:chOff x="6248400" y="31623000"/>
                <a:chExt cx="533400" cy="97972"/>
              </a:xfrm>
            </p:grpSpPr>
            <p:sp>
              <p:nvSpPr>
                <p:cNvPr id="107" name="Pentagon 106"/>
                <p:cNvSpPr/>
                <p:nvPr/>
              </p:nvSpPr>
              <p:spPr>
                <a:xfrm>
                  <a:off x="6324600" y="31623000"/>
                  <a:ext cx="457200" cy="97971"/>
                </a:xfrm>
                <a:prstGeom prst="homePlate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08" name="Rectangle 107"/>
                <p:cNvSpPr/>
                <p:nvPr/>
              </p:nvSpPr>
              <p:spPr>
                <a:xfrm>
                  <a:off x="6248400" y="31623000"/>
                  <a:ext cx="81643" cy="97972"/>
                </a:xfrm>
                <a:prstGeom prst="rect">
                  <a:avLst/>
                </a:prstGeom>
                <a:solidFill>
                  <a:schemeClr val="accent3">
                    <a:lumMod val="7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83" name="Group 145"/>
              <p:cNvGrpSpPr/>
              <p:nvPr/>
            </p:nvGrpSpPr>
            <p:grpSpPr>
              <a:xfrm>
                <a:off x="9780713" y="30556200"/>
                <a:ext cx="533400" cy="97972"/>
                <a:chOff x="6400800" y="31775400"/>
                <a:chExt cx="533400" cy="97972"/>
              </a:xfrm>
            </p:grpSpPr>
            <p:sp>
              <p:nvSpPr>
                <p:cNvPr id="105" name="Pentagon 104"/>
                <p:cNvSpPr/>
                <p:nvPr/>
              </p:nvSpPr>
              <p:spPr>
                <a:xfrm>
                  <a:off x="6477000" y="31775400"/>
                  <a:ext cx="457200" cy="97971"/>
                </a:xfrm>
                <a:prstGeom prst="homePlate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06" name="Rectangle 105"/>
                <p:cNvSpPr/>
                <p:nvPr/>
              </p:nvSpPr>
              <p:spPr>
                <a:xfrm>
                  <a:off x="6400800" y="31775400"/>
                  <a:ext cx="81643" cy="97972"/>
                </a:xfrm>
                <a:prstGeom prst="rect">
                  <a:avLst/>
                </a:prstGeom>
                <a:solidFill>
                  <a:schemeClr val="accent2">
                    <a:lumMod val="7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84" name="Group 136"/>
              <p:cNvGrpSpPr/>
              <p:nvPr/>
            </p:nvGrpSpPr>
            <p:grpSpPr>
              <a:xfrm>
                <a:off x="9780713" y="29641800"/>
                <a:ext cx="533400" cy="97972"/>
                <a:chOff x="6248400" y="32080200"/>
                <a:chExt cx="533400" cy="97972"/>
              </a:xfrm>
            </p:grpSpPr>
            <p:sp>
              <p:nvSpPr>
                <p:cNvPr id="103" name="Pentagon 102"/>
                <p:cNvSpPr/>
                <p:nvPr/>
              </p:nvSpPr>
              <p:spPr>
                <a:xfrm>
                  <a:off x="6324600" y="32080200"/>
                  <a:ext cx="457200" cy="97971"/>
                </a:xfrm>
                <a:prstGeom prst="homePlate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04" name="Rectangle 103"/>
                <p:cNvSpPr/>
                <p:nvPr/>
              </p:nvSpPr>
              <p:spPr>
                <a:xfrm>
                  <a:off x="6248400" y="32080200"/>
                  <a:ext cx="81643" cy="97972"/>
                </a:xfrm>
                <a:prstGeom prst="rect">
                  <a:avLst/>
                </a:prstGeom>
                <a:solidFill>
                  <a:schemeClr val="accent2">
                    <a:lumMod val="7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85" name="Group 146"/>
              <p:cNvGrpSpPr/>
              <p:nvPr/>
            </p:nvGrpSpPr>
            <p:grpSpPr>
              <a:xfrm>
                <a:off x="9094913" y="29946600"/>
                <a:ext cx="533400" cy="97972"/>
                <a:chOff x="6400800" y="32232600"/>
                <a:chExt cx="533400" cy="97972"/>
              </a:xfrm>
            </p:grpSpPr>
            <p:sp>
              <p:nvSpPr>
                <p:cNvPr id="101" name="Pentagon 100"/>
                <p:cNvSpPr/>
                <p:nvPr/>
              </p:nvSpPr>
              <p:spPr>
                <a:xfrm>
                  <a:off x="6477000" y="32232600"/>
                  <a:ext cx="457200" cy="97971"/>
                </a:xfrm>
                <a:prstGeom prst="homePlate">
                  <a:avLst/>
                </a:prstGeom>
                <a:solidFill>
                  <a:schemeClr val="accent3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02" name="Rectangle 101"/>
                <p:cNvSpPr/>
                <p:nvPr/>
              </p:nvSpPr>
              <p:spPr>
                <a:xfrm>
                  <a:off x="6400800" y="32232600"/>
                  <a:ext cx="81643" cy="97972"/>
                </a:xfrm>
                <a:prstGeom prst="rect">
                  <a:avLst/>
                </a:prstGeom>
                <a:solidFill>
                  <a:schemeClr val="accent3">
                    <a:lumMod val="7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86" name="Group 147"/>
              <p:cNvGrpSpPr/>
              <p:nvPr/>
            </p:nvGrpSpPr>
            <p:grpSpPr>
              <a:xfrm>
                <a:off x="9094913" y="29641800"/>
                <a:ext cx="533400" cy="97972"/>
                <a:chOff x="6553200" y="32385000"/>
                <a:chExt cx="533400" cy="97972"/>
              </a:xfrm>
            </p:grpSpPr>
            <p:sp>
              <p:nvSpPr>
                <p:cNvPr id="99" name="Pentagon 98"/>
                <p:cNvSpPr/>
                <p:nvPr/>
              </p:nvSpPr>
              <p:spPr>
                <a:xfrm>
                  <a:off x="6629400" y="32385000"/>
                  <a:ext cx="457200" cy="97971"/>
                </a:xfrm>
                <a:prstGeom prst="homePlate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00" name="Rectangle 99"/>
                <p:cNvSpPr/>
                <p:nvPr/>
              </p:nvSpPr>
              <p:spPr>
                <a:xfrm>
                  <a:off x="6553200" y="32385000"/>
                  <a:ext cx="81643" cy="97972"/>
                </a:xfrm>
                <a:prstGeom prst="rect">
                  <a:avLst/>
                </a:prstGeom>
                <a:solidFill>
                  <a:schemeClr val="accent3">
                    <a:lumMod val="7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cxnSp>
            <p:nvCxnSpPr>
              <p:cNvPr id="87" name="Straight Connector 86"/>
              <p:cNvCxnSpPr/>
              <p:nvPr/>
            </p:nvCxnSpPr>
            <p:spPr>
              <a:xfrm rot="5400000">
                <a:off x="7658100" y="29832300"/>
                <a:ext cx="381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Straight Connector 87"/>
              <p:cNvCxnSpPr/>
              <p:nvPr/>
            </p:nvCxnSpPr>
            <p:spPr>
              <a:xfrm>
                <a:off x="7848600" y="29641800"/>
                <a:ext cx="381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Straight Connector 88"/>
              <p:cNvCxnSpPr/>
              <p:nvPr/>
            </p:nvCxnSpPr>
            <p:spPr>
              <a:xfrm>
                <a:off x="7848600" y="30022800"/>
                <a:ext cx="381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Straight Connector 89"/>
              <p:cNvCxnSpPr/>
              <p:nvPr/>
            </p:nvCxnSpPr>
            <p:spPr>
              <a:xfrm rot="10800000">
                <a:off x="7467600" y="29794200"/>
                <a:ext cx="381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Straight Connector 90"/>
              <p:cNvCxnSpPr/>
              <p:nvPr/>
            </p:nvCxnSpPr>
            <p:spPr>
              <a:xfrm rot="5400000">
                <a:off x="7200900" y="30060900"/>
                <a:ext cx="5334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Straight Connector 91"/>
              <p:cNvCxnSpPr/>
              <p:nvPr/>
            </p:nvCxnSpPr>
            <p:spPr>
              <a:xfrm>
                <a:off x="7467600" y="30327600"/>
                <a:ext cx="762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Straight Connector 92"/>
              <p:cNvCxnSpPr/>
              <p:nvPr/>
            </p:nvCxnSpPr>
            <p:spPr>
              <a:xfrm rot="10800000">
                <a:off x="7162800" y="30099000"/>
                <a:ext cx="3048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Straight Connector 93"/>
              <p:cNvCxnSpPr/>
              <p:nvPr/>
            </p:nvCxnSpPr>
            <p:spPr>
              <a:xfrm rot="5400000">
                <a:off x="6896100" y="30365700"/>
                <a:ext cx="5334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Straight Connector 94"/>
              <p:cNvCxnSpPr/>
              <p:nvPr/>
            </p:nvCxnSpPr>
            <p:spPr>
              <a:xfrm>
                <a:off x="7162800" y="30632400"/>
                <a:ext cx="10668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6" name="TextBox 95"/>
              <p:cNvSpPr txBox="1"/>
              <p:nvPr/>
            </p:nvSpPr>
            <p:spPr>
              <a:xfrm>
                <a:off x="8181438" y="29260800"/>
                <a:ext cx="836019" cy="3208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 err="1"/>
                  <a:t>SampleA</a:t>
                </a:r>
                <a:endParaRPr lang="en-US" sz="1000" dirty="0"/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>
                <a:off x="8894837" y="29260800"/>
                <a:ext cx="831841" cy="3208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 err="1"/>
                  <a:t>SampleB</a:t>
                </a:r>
                <a:endParaRPr lang="en-US" sz="1000" dirty="0"/>
              </a:p>
            </p:txBody>
          </p:sp>
          <p:sp>
            <p:nvSpPr>
              <p:cNvPr id="98" name="TextBox 97"/>
              <p:cNvSpPr txBox="1"/>
              <p:nvPr/>
            </p:nvSpPr>
            <p:spPr>
              <a:xfrm>
                <a:off x="9607993" y="29260800"/>
                <a:ext cx="829753" cy="3208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 err="1"/>
                  <a:t>SampleC</a:t>
                </a:r>
                <a:endParaRPr lang="en-US" sz="1000" dirty="0"/>
              </a:p>
            </p:txBody>
          </p:sp>
        </p:grpSp>
        <p:pic>
          <p:nvPicPr>
            <p:cNvPr id="11266" name="Picture 2" descr="http://cdn-1.about-bees.com/graphics/bee6-c.jpg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 flipH="1">
              <a:off x="5410200" y="1219200"/>
              <a:ext cx="935558" cy="935558"/>
            </a:xfrm>
            <a:prstGeom prst="rect">
              <a:avLst/>
            </a:prstGeom>
            <a:noFill/>
          </p:spPr>
        </p:pic>
        <p:sp>
          <p:nvSpPr>
            <p:cNvPr id="159" name="Left Arrow 158"/>
            <p:cNvSpPr/>
            <p:nvPr/>
          </p:nvSpPr>
          <p:spPr>
            <a:xfrm>
              <a:off x="6629400" y="1676400"/>
              <a:ext cx="526251" cy="233889"/>
            </a:xfrm>
            <a:prstGeom prst="lef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11268" name="Picture 4" descr="https://springstar.net/products/ZBVT.jpg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7467600" y="1219200"/>
              <a:ext cx="526251" cy="1020038"/>
            </a:xfrm>
            <a:prstGeom prst="rect">
              <a:avLst/>
            </a:prstGeom>
            <a:noFill/>
          </p:spPr>
        </p:pic>
        <p:sp>
          <p:nvSpPr>
            <p:cNvPr id="162" name="Left Arrow 161"/>
            <p:cNvSpPr/>
            <p:nvPr/>
          </p:nvSpPr>
          <p:spPr>
            <a:xfrm rot="16200000">
              <a:off x="1682619" y="2965581"/>
              <a:ext cx="526251" cy="233889"/>
            </a:xfrm>
            <a:prstGeom prst="lef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3" name="Text Box 66"/>
            <p:cNvSpPr txBox="1">
              <a:spLocks noChangeArrowheads="1"/>
            </p:cNvSpPr>
            <p:nvPr/>
          </p:nvSpPr>
          <p:spPr bwMode="auto">
            <a:xfrm>
              <a:off x="3124200" y="4800600"/>
              <a:ext cx="1752600" cy="53340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ea typeface="Calibri" pitchFamily="34" charset="0"/>
                  <a:cs typeface="Times New Roman" pitchFamily="18" charset="0"/>
                </a:rPr>
                <a:t>6. High-throughput sequencing</a:t>
              </a:r>
              <a:endParaRPr kumimoji="0" 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4" name="Text Box 64"/>
            <p:cNvSpPr txBox="1">
              <a:spLocks noChangeArrowheads="1"/>
            </p:cNvSpPr>
            <p:nvPr/>
          </p:nvSpPr>
          <p:spPr bwMode="auto">
            <a:xfrm>
              <a:off x="990600" y="4800600"/>
              <a:ext cx="1905000" cy="53340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ea typeface="Calibri" pitchFamily="34" charset="0"/>
                  <a:cs typeface="Times New Roman" pitchFamily="18" charset="0"/>
                </a:rPr>
                <a:t>5.</a:t>
              </a:r>
              <a:r>
                <a:rPr kumimoji="0" lang="en-US" sz="1400" b="0" i="0" u="none" strike="noStrike" cap="none" normalizeH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ea typeface="Calibri" pitchFamily="34" charset="0"/>
                  <a:cs typeface="Times New Roman" pitchFamily="18" charset="0"/>
                </a:rPr>
                <a:t> P</a:t>
              </a:r>
              <a:r>
                <a:rPr kumimoji="0" 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ea typeface="Calibri" pitchFamily="34" charset="0"/>
                  <a:cs typeface="Times New Roman" pitchFamily="18" charset="0"/>
                </a:rPr>
                <a:t>rimer design and library preparation</a:t>
              </a:r>
              <a:endParaRPr kumimoji="0" 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5" name="Text Box 23"/>
            <p:cNvSpPr txBox="1">
              <a:spLocks noChangeArrowheads="1"/>
            </p:cNvSpPr>
            <p:nvPr/>
          </p:nvSpPr>
          <p:spPr bwMode="auto">
            <a:xfrm>
              <a:off x="6253111" y="4728200"/>
              <a:ext cx="2433689" cy="60580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ea typeface="Calibri" pitchFamily="34" charset="0"/>
                  <a:cs typeface="Times New Roman" pitchFamily="18" charset="0"/>
                </a:rPr>
                <a:t>8. </a:t>
              </a:r>
              <a:r>
                <a:rPr kumimoji="0" lang="en-US" sz="14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ea typeface="Calibri" pitchFamily="34" charset="0"/>
                  <a:cs typeface="Times New Roman" pitchFamily="18" charset="0"/>
                </a:rPr>
                <a:t>Bioinformatically</a:t>
              </a:r>
              <a:r>
                <a:rPr kumimoji="0" 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ea typeface="Calibri" pitchFamily="34" charset="0"/>
                  <a:cs typeface="Times New Roman" pitchFamily="18" charset="0"/>
                </a:rPr>
                <a:t> sort reads by sample and species</a:t>
              </a:r>
              <a:endParaRPr kumimoji="0" 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" name="Title 2">
            <a:extLst>
              <a:ext uri="{FF2B5EF4-FFF2-40B4-BE49-F238E27FC236}">
                <a16:creationId xmlns:a16="http://schemas.microsoft.com/office/drawing/2014/main" id="{8AEE794B-0DD5-4889-A551-A6E7F22087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equencing Pipeline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B5C33B-2A71-4FB0-A439-4D6C9D9CC9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Springstar</a:t>
            </a:r>
            <a:r>
              <a:rPr lang="en-US" baseline="30000" dirty="0" err="1"/>
              <a:t>TM</a:t>
            </a:r>
            <a:r>
              <a:rPr lang="en-US" dirty="0"/>
              <a:t> blue vane trap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5564651-E66D-4760-B0E6-FD7AB537478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95600" y="1554162"/>
            <a:ext cx="3352800" cy="5029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75235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DC86FD-3B9E-482D-AAB7-9FCB0CD714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issue Preparation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A9318BA6-1814-4A85-8924-BDC81017FDD6}"/>
              </a:ext>
            </a:extLst>
          </p:cNvPr>
          <p:cNvGrpSpPr/>
          <p:nvPr/>
        </p:nvGrpSpPr>
        <p:grpSpPr>
          <a:xfrm>
            <a:off x="379116" y="1371600"/>
            <a:ext cx="8523241" cy="5189106"/>
            <a:chOff x="379116" y="1516388"/>
            <a:chExt cx="8523241" cy="5189106"/>
          </a:xfrm>
        </p:grpSpPr>
        <p:pic>
          <p:nvPicPr>
            <p:cNvPr id="1026" name="Picture 2" descr="bee silhouette by jarda">
              <a:extLst>
                <a:ext uri="{FF2B5EF4-FFF2-40B4-BE49-F238E27FC236}">
                  <a16:creationId xmlns:a16="http://schemas.microsoft.com/office/drawing/2014/main" id="{49A4BF55-C41E-485D-B22A-FABE02DE217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65998" y="2485880"/>
              <a:ext cx="997798" cy="638175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04BC96E8-4A9C-449F-A350-B11585F9EE75}"/>
                </a:ext>
              </a:extLst>
            </p:cNvPr>
            <p:cNvSpPr txBox="1"/>
            <p:nvPr/>
          </p:nvSpPr>
          <p:spPr>
            <a:xfrm>
              <a:off x="2209800" y="1711087"/>
              <a:ext cx="7101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axa1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2EF965D-7EDB-4970-836F-8AFF818A946E}"/>
                </a:ext>
              </a:extLst>
            </p:cNvPr>
            <p:cNvSpPr txBox="1"/>
            <p:nvPr/>
          </p:nvSpPr>
          <p:spPr>
            <a:xfrm>
              <a:off x="457200" y="2743200"/>
              <a:ext cx="100860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/>
                <a:t>SampleA</a:t>
              </a:r>
              <a:endParaRPr lang="en-US" dirty="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E446B3F-7CCE-4D21-B5B2-F256D9B57D0F}"/>
                </a:ext>
              </a:extLst>
            </p:cNvPr>
            <p:cNvSpPr txBox="1"/>
            <p:nvPr/>
          </p:nvSpPr>
          <p:spPr>
            <a:xfrm>
              <a:off x="4038600" y="1711087"/>
              <a:ext cx="7101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axa2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13E2259-E370-4150-B778-46DADC1390D6}"/>
                </a:ext>
              </a:extLst>
            </p:cNvPr>
            <p:cNvSpPr txBox="1"/>
            <p:nvPr/>
          </p:nvSpPr>
          <p:spPr>
            <a:xfrm>
              <a:off x="5867400" y="1711087"/>
              <a:ext cx="7101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axa3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6531E57-5B5D-4C5F-A70E-DE297FD5070A}"/>
                </a:ext>
              </a:extLst>
            </p:cNvPr>
            <p:cNvSpPr txBox="1"/>
            <p:nvPr/>
          </p:nvSpPr>
          <p:spPr>
            <a:xfrm>
              <a:off x="457200" y="5027096"/>
              <a:ext cx="9989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/>
                <a:t>SampleC</a:t>
              </a:r>
              <a:endParaRPr lang="en-US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2EB605F-1339-4B88-804E-24E9683BCBA5}"/>
                </a:ext>
              </a:extLst>
            </p:cNvPr>
            <p:cNvSpPr txBox="1"/>
            <p:nvPr/>
          </p:nvSpPr>
          <p:spPr>
            <a:xfrm>
              <a:off x="457200" y="3885148"/>
              <a:ext cx="10005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/>
                <a:t>SampleB</a:t>
              </a:r>
              <a:endParaRPr lang="en-US" dirty="0"/>
            </a:p>
          </p:txBody>
        </p:sp>
        <p:pic>
          <p:nvPicPr>
            <p:cNvPr id="10" name="Picture 2" descr="bee silhouette by jarda">
              <a:extLst>
                <a:ext uri="{FF2B5EF4-FFF2-40B4-BE49-F238E27FC236}">
                  <a16:creationId xmlns:a16="http://schemas.microsoft.com/office/drawing/2014/main" id="{CAD03133-C66A-48BA-B21D-91EE5E73573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65998" y="4892674"/>
              <a:ext cx="997798" cy="638175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" name="Picture 2" descr="bee silhouette by jarda">
              <a:extLst>
                <a:ext uri="{FF2B5EF4-FFF2-40B4-BE49-F238E27FC236}">
                  <a16:creationId xmlns:a16="http://schemas.microsoft.com/office/drawing/2014/main" id="{7BED96BC-01B2-418F-AF6F-96C5F3C1445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82941" y="4892673"/>
              <a:ext cx="997798" cy="638175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" name="Picture 2" descr="bee silhouette by jarda">
              <a:extLst>
                <a:ext uri="{FF2B5EF4-FFF2-40B4-BE49-F238E27FC236}">
                  <a16:creationId xmlns:a16="http://schemas.microsoft.com/office/drawing/2014/main" id="{AA26B0AE-9EF4-4096-B92F-1A646F6360C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79796" y="3566060"/>
              <a:ext cx="997798" cy="638175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" name="Picture 2" descr="bee silhouette by jarda">
              <a:extLst>
                <a:ext uri="{FF2B5EF4-FFF2-40B4-BE49-F238E27FC236}">
                  <a16:creationId xmlns:a16="http://schemas.microsoft.com/office/drawing/2014/main" id="{17065EEA-C5B0-42BB-9924-27C08EDA988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79796" y="2478391"/>
              <a:ext cx="997798" cy="638175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" name="Picture 2" descr="bee silhouette by jarda">
              <a:extLst>
                <a:ext uri="{FF2B5EF4-FFF2-40B4-BE49-F238E27FC236}">
                  <a16:creationId xmlns:a16="http://schemas.microsoft.com/office/drawing/2014/main" id="{1B6AD21E-D869-4D37-A8C5-5C162DEEBD3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08652" y="4892674"/>
              <a:ext cx="997798" cy="638175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5" name="Picture 2" descr="bee silhouette by jarda">
              <a:extLst>
                <a:ext uri="{FF2B5EF4-FFF2-40B4-BE49-F238E27FC236}">
                  <a16:creationId xmlns:a16="http://schemas.microsoft.com/office/drawing/2014/main" id="{92A8761D-0C1B-422F-9D16-B984A694DBF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94798" y="3566060"/>
              <a:ext cx="997798" cy="638175"/>
            </a:xfrm>
            <a:prstGeom prst="rect">
              <a:avLst/>
            </a:prstGeom>
            <a:noFill/>
          </p:spPr>
        </p:pic>
        <p:pic>
          <p:nvPicPr>
            <p:cNvPr id="1028" name="Picture 4" descr="Image result for microcentrifuge tube">
              <a:extLst>
                <a:ext uri="{FF2B5EF4-FFF2-40B4-BE49-F238E27FC236}">
                  <a16:creationId xmlns:a16="http://schemas.microsoft.com/office/drawing/2014/main" id="{8AD4B0C7-F1F4-4BDC-86F5-0FC585A4EA9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09800" y="5715000"/>
              <a:ext cx="990494" cy="990494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7" name="Picture 4" descr="Image result for microcentrifuge tube">
              <a:extLst>
                <a:ext uri="{FF2B5EF4-FFF2-40B4-BE49-F238E27FC236}">
                  <a16:creationId xmlns:a16="http://schemas.microsoft.com/office/drawing/2014/main" id="{88CFFABC-ED1C-4DDE-9A07-492107F63A4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76753" y="5686735"/>
              <a:ext cx="990494" cy="990494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8" name="Picture 4" descr="Image result for microcentrifuge tube">
              <a:extLst>
                <a:ext uri="{FF2B5EF4-FFF2-40B4-BE49-F238E27FC236}">
                  <a16:creationId xmlns:a16="http://schemas.microsoft.com/office/drawing/2014/main" id="{5EB87E90-45CF-408B-89D8-2E9D78BEA02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27250" y="5657601"/>
              <a:ext cx="990494" cy="990494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" name="Picture 4" descr="Image result for microcentrifuge tube">
              <a:extLst>
                <a:ext uri="{FF2B5EF4-FFF2-40B4-BE49-F238E27FC236}">
                  <a16:creationId xmlns:a16="http://schemas.microsoft.com/office/drawing/2014/main" id="{E2A2F128-35D7-4493-8B68-D1A25773281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377747" y="2164661"/>
              <a:ext cx="990494" cy="990494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" name="Picture 4" descr="Image result for microcentrifuge tube">
              <a:extLst>
                <a:ext uri="{FF2B5EF4-FFF2-40B4-BE49-F238E27FC236}">
                  <a16:creationId xmlns:a16="http://schemas.microsoft.com/office/drawing/2014/main" id="{A21B1006-5F18-4569-94AD-AD2F0A5AF41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381060" y="3263986"/>
              <a:ext cx="990494" cy="990494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1" name="Picture 4" descr="Image result for microcentrifuge tube">
              <a:extLst>
                <a:ext uri="{FF2B5EF4-FFF2-40B4-BE49-F238E27FC236}">
                  <a16:creationId xmlns:a16="http://schemas.microsoft.com/office/drawing/2014/main" id="{A95F4770-6B42-4DC2-AB7F-553F7C70244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377747" y="4667107"/>
              <a:ext cx="990494" cy="990494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Oval 3">
              <a:extLst>
                <a:ext uri="{FF2B5EF4-FFF2-40B4-BE49-F238E27FC236}">
                  <a16:creationId xmlns:a16="http://schemas.microsoft.com/office/drawing/2014/main" id="{E96AFD2D-DC38-48C7-9463-1F091B79BAE7}"/>
                </a:ext>
              </a:extLst>
            </p:cNvPr>
            <p:cNvSpPr/>
            <p:nvPr/>
          </p:nvSpPr>
          <p:spPr>
            <a:xfrm>
              <a:off x="2065998" y="2743200"/>
              <a:ext cx="372402" cy="369332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Oval 22">
              <a:extLst>
                <a:ext uri="{FF2B5EF4-FFF2-40B4-BE49-F238E27FC236}">
                  <a16:creationId xmlns:a16="http://schemas.microsoft.com/office/drawing/2014/main" id="{11D8E988-4EDA-4449-827D-22896ADB3F01}"/>
                </a:ext>
              </a:extLst>
            </p:cNvPr>
            <p:cNvSpPr/>
            <p:nvPr/>
          </p:nvSpPr>
          <p:spPr>
            <a:xfrm>
              <a:off x="2090477" y="5162354"/>
              <a:ext cx="372402" cy="369332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Oval 23">
              <a:extLst>
                <a:ext uri="{FF2B5EF4-FFF2-40B4-BE49-F238E27FC236}">
                  <a16:creationId xmlns:a16="http://schemas.microsoft.com/office/drawing/2014/main" id="{D97814C1-B77A-4655-9D97-83C9DBBC6C4C}"/>
                </a:ext>
              </a:extLst>
            </p:cNvPr>
            <p:cNvSpPr/>
            <p:nvPr/>
          </p:nvSpPr>
          <p:spPr>
            <a:xfrm>
              <a:off x="2671476" y="2662133"/>
              <a:ext cx="372402" cy="369332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Oval 24">
              <a:extLst>
                <a:ext uri="{FF2B5EF4-FFF2-40B4-BE49-F238E27FC236}">
                  <a16:creationId xmlns:a16="http://schemas.microsoft.com/office/drawing/2014/main" id="{FB99BCC7-65E2-4284-BFF8-85D766A77E0A}"/>
                </a:ext>
              </a:extLst>
            </p:cNvPr>
            <p:cNvSpPr/>
            <p:nvPr/>
          </p:nvSpPr>
          <p:spPr>
            <a:xfrm>
              <a:off x="6209122" y="2654711"/>
              <a:ext cx="372402" cy="369332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Freeform: Shape 15">
              <a:extLst>
                <a:ext uri="{FF2B5EF4-FFF2-40B4-BE49-F238E27FC236}">
                  <a16:creationId xmlns:a16="http://schemas.microsoft.com/office/drawing/2014/main" id="{FC89E531-E5A5-499D-BB43-463B13413E64}"/>
                </a:ext>
              </a:extLst>
            </p:cNvPr>
            <p:cNvSpPr/>
            <p:nvPr/>
          </p:nvSpPr>
          <p:spPr>
            <a:xfrm>
              <a:off x="1447791" y="3011557"/>
              <a:ext cx="848148" cy="3180521"/>
            </a:xfrm>
            <a:custGeom>
              <a:avLst/>
              <a:gdLst>
                <a:gd name="connsiteX0" fmla="*/ 629487 w 848148"/>
                <a:gd name="connsiteY0" fmla="*/ 0 h 3180521"/>
                <a:gd name="connsiteX1" fmla="*/ 291557 w 848148"/>
                <a:gd name="connsiteY1" fmla="*/ 487017 h 3180521"/>
                <a:gd name="connsiteX2" fmla="*/ 3322 w 848148"/>
                <a:gd name="connsiteY2" fmla="*/ 1620078 h 3180521"/>
                <a:gd name="connsiteX3" fmla="*/ 182226 w 848148"/>
                <a:gd name="connsiteY3" fmla="*/ 2653747 h 3180521"/>
                <a:gd name="connsiteX4" fmla="*/ 848148 w 848148"/>
                <a:gd name="connsiteY4" fmla="*/ 3180521 h 318052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848148" h="3180521">
                  <a:moveTo>
                    <a:pt x="629487" y="0"/>
                  </a:moveTo>
                  <a:cubicBezTo>
                    <a:pt x="512702" y="108502"/>
                    <a:pt x="395918" y="217004"/>
                    <a:pt x="291557" y="487017"/>
                  </a:cubicBezTo>
                  <a:cubicBezTo>
                    <a:pt x="187196" y="757030"/>
                    <a:pt x="21544" y="1258956"/>
                    <a:pt x="3322" y="1620078"/>
                  </a:cubicBezTo>
                  <a:cubicBezTo>
                    <a:pt x="-14900" y="1981200"/>
                    <a:pt x="41422" y="2393673"/>
                    <a:pt x="182226" y="2653747"/>
                  </a:cubicBezTo>
                  <a:cubicBezTo>
                    <a:pt x="323030" y="2913821"/>
                    <a:pt x="585589" y="3047171"/>
                    <a:pt x="848148" y="3180521"/>
                  </a:cubicBezTo>
                </a:path>
              </a:pathLst>
            </a:custGeom>
            <a:noFill/>
            <a:ln>
              <a:headEnd type="none" w="med" len="med"/>
              <a:tailEnd type="triangle" w="med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Freeform: Shape 21">
              <a:extLst>
                <a:ext uri="{FF2B5EF4-FFF2-40B4-BE49-F238E27FC236}">
                  <a16:creationId xmlns:a16="http://schemas.microsoft.com/office/drawing/2014/main" id="{2036B060-16BE-4B4B-AD7D-EDC67BF26D95}"/>
                </a:ext>
              </a:extLst>
            </p:cNvPr>
            <p:cNvSpPr/>
            <p:nvPr/>
          </p:nvSpPr>
          <p:spPr>
            <a:xfrm>
              <a:off x="1957881" y="5406887"/>
              <a:ext cx="318180" cy="785191"/>
            </a:xfrm>
            <a:custGeom>
              <a:avLst/>
              <a:gdLst>
                <a:gd name="connsiteX0" fmla="*/ 119397 w 318180"/>
                <a:gd name="connsiteY0" fmla="*/ 0 h 785191"/>
                <a:gd name="connsiteX1" fmla="*/ 128 w 318180"/>
                <a:gd name="connsiteY1" fmla="*/ 248478 h 785191"/>
                <a:gd name="connsiteX2" fmla="*/ 139276 w 318180"/>
                <a:gd name="connsiteY2" fmla="*/ 596348 h 785191"/>
                <a:gd name="connsiteX3" fmla="*/ 318180 w 318180"/>
                <a:gd name="connsiteY3" fmla="*/ 785191 h 78519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18180" h="785191">
                  <a:moveTo>
                    <a:pt x="119397" y="0"/>
                  </a:moveTo>
                  <a:cubicBezTo>
                    <a:pt x="58106" y="74543"/>
                    <a:pt x="-3185" y="149087"/>
                    <a:pt x="128" y="248478"/>
                  </a:cubicBezTo>
                  <a:cubicBezTo>
                    <a:pt x="3441" y="347869"/>
                    <a:pt x="86267" y="506896"/>
                    <a:pt x="139276" y="596348"/>
                  </a:cubicBezTo>
                  <a:cubicBezTo>
                    <a:pt x="192285" y="685800"/>
                    <a:pt x="255232" y="735495"/>
                    <a:pt x="318180" y="785191"/>
                  </a:cubicBezTo>
                </a:path>
              </a:pathLst>
            </a:custGeom>
            <a:noFill/>
            <a:ln>
              <a:headEnd type="none" w="med" len="med"/>
              <a:tailEnd type="triangle" w="med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Freeform: Shape 25">
              <a:extLst>
                <a:ext uri="{FF2B5EF4-FFF2-40B4-BE49-F238E27FC236}">
                  <a16:creationId xmlns:a16="http://schemas.microsoft.com/office/drawing/2014/main" id="{4F04647F-2702-4577-8E16-97A99B40DF1D}"/>
                </a:ext>
              </a:extLst>
            </p:cNvPr>
            <p:cNvSpPr/>
            <p:nvPr/>
          </p:nvSpPr>
          <p:spPr>
            <a:xfrm>
              <a:off x="3001617" y="2074601"/>
              <a:ext cx="4552122" cy="628842"/>
            </a:xfrm>
            <a:custGeom>
              <a:avLst/>
              <a:gdLst>
                <a:gd name="connsiteX0" fmla="*/ 0 w 4552122"/>
                <a:gd name="connsiteY0" fmla="*/ 628842 h 628842"/>
                <a:gd name="connsiteX1" fmla="*/ 646044 w 4552122"/>
                <a:gd name="connsiteY1" fmla="*/ 360486 h 628842"/>
                <a:gd name="connsiteX2" fmla="*/ 2286000 w 4552122"/>
                <a:gd name="connsiteY2" fmla="*/ 42434 h 628842"/>
                <a:gd name="connsiteX3" fmla="*/ 3548270 w 4552122"/>
                <a:gd name="connsiteY3" fmla="*/ 22556 h 628842"/>
                <a:gd name="connsiteX4" fmla="*/ 4552122 w 4552122"/>
                <a:gd name="connsiteY4" fmla="*/ 221338 h 62884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4552122" h="628842">
                  <a:moveTo>
                    <a:pt x="0" y="628842"/>
                  </a:moveTo>
                  <a:cubicBezTo>
                    <a:pt x="132522" y="543531"/>
                    <a:pt x="265044" y="458221"/>
                    <a:pt x="646044" y="360486"/>
                  </a:cubicBezTo>
                  <a:cubicBezTo>
                    <a:pt x="1027044" y="262751"/>
                    <a:pt x="1802296" y="98756"/>
                    <a:pt x="2286000" y="42434"/>
                  </a:cubicBezTo>
                  <a:cubicBezTo>
                    <a:pt x="2769704" y="-13888"/>
                    <a:pt x="3170583" y="-7261"/>
                    <a:pt x="3548270" y="22556"/>
                  </a:cubicBezTo>
                  <a:cubicBezTo>
                    <a:pt x="3925957" y="52373"/>
                    <a:pt x="4239039" y="136855"/>
                    <a:pt x="4552122" y="221338"/>
                  </a:cubicBezTo>
                </a:path>
              </a:pathLst>
            </a:custGeom>
            <a:noFill/>
            <a:ln>
              <a:headEnd type="none" w="med" len="med"/>
              <a:tailEnd type="triangle" w="med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Freeform: Shape 26">
              <a:extLst>
                <a:ext uri="{FF2B5EF4-FFF2-40B4-BE49-F238E27FC236}">
                  <a16:creationId xmlns:a16="http://schemas.microsoft.com/office/drawing/2014/main" id="{566B73AB-80CC-4FA5-9F27-BCD938B4529A}"/>
                </a:ext>
              </a:extLst>
            </p:cNvPr>
            <p:cNvSpPr/>
            <p:nvPr/>
          </p:nvSpPr>
          <p:spPr>
            <a:xfrm>
              <a:off x="6530009" y="2673626"/>
              <a:ext cx="964095" cy="349782"/>
            </a:xfrm>
            <a:custGeom>
              <a:avLst/>
              <a:gdLst>
                <a:gd name="connsiteX0" fmla="*/ 0 w 964095"/>
                <a:gd name="connsiteY0" fmla="*/ 347870 h 349782"/>
                <a:gd name="connsiteX1" fmla="*/ 327991 w 964095"/>
                <a:gd name="connsiteY1" fmla="*/ 318052 h 349782"/>
                <a:gd name="connsiteX2" fmla="*/ 735495 w 964095"/>
                <a:gd name="connsiteY2" fmla="*/ 129209 h 349782"/>
                <a:gd name="connsiteX3" fmla="*/ 964095 w 964095"/>
                <a:gd name="connsiteY3" fmla="*/ 0 h 3497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964095" h="349782">
                  <a:moveTo>
                    <a:pt x="0" y="347870"/>
                  </a:moveTo>
                  <a:cubicBezTo>
                    <a:pt x="102704" y="351182"/>
                    <a:pt x="205409" y="354495"/>
                    <a:pt x="327991" y="318052"/>
                  </a:cubicBezTo>
                  <a:cubicBezTo>
                    <a:pt x="450573" y="281609"/>
                    <a:pt x="629478" y="182218"/>
                    <a:pt x="735495" y="129209"/>
                  </a:cubicBezTo>
                  <a:cubicBezTo>
                    <a:pt x="841512" y="76200"/>
                    <a:pt x="902803" y="38100"/>
                    <a:pt x="964095" y="0"/>
                  </a:cubicBezTo>
                </a:path>
              </a:pathLst>
            </a:custGeom>
            <a:noFill/>
            <a:ln>
              <a:headEnd type="none" w="med" len="med"/>
              <a:tailEnd type="triangle" w="med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FF253FBF-8B1E-4040-ABCB-273EB6B6701D}"/>
                </a:ext>
              </a:extLst>
            </p:cNvPr>
            <p:cNvSpPr txBox="1"/>
            <p:nvPr/>
          </p:nvSpPr>
          <p:spPr>
            <a:xfrm>
              <a:off x="7315200" y="1516388"/>
              <a:ext cx="15577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One leg for each “Sample” tube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75171BD4-5450-4817-BE44-510E31E01A77}"/>
                </a:ext>
              </a:extLst>
            </p:cNvPr>
            <p:cNvSpPr txBox="1"/>
            <p:nvPr/>
          </p:nvSpPr>
          <p:spPr>
            <a:xfrm>
              <a:off x="379116" y="6108310"/>
              <a:ext cx="168688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One leg for each “Taxa” Tube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4B862631-229E-4F9A-9E02-BC88B7EBC3A6}"/>
                </a:ext>
              </a:extLst>
            </p:cNvPr>
            <p:cNvSpPr txBox="1"/>
            <p:nvPr/>
          </p:nvSpPr>
          <p:spPr>
            <a:xfrm>
              <a:off x="7344617" y="6182274"/>
              <a:ext cx="15577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Five ceramic beads for each tube</a:t>
              </a:r>
            </a:p>
          </p:txBody>
        </p:sp>
        <p:sp>
          <p:nvSpPr>
            <p:cNvPr id="28" name="Oval 27">
              <a:extLst>
                <a:ext uri="{FF2B5EF4-FFF2-40B4-BE49-F238E27FC236}">
                  <a16:creationId xmlns:a16="http://schemas.microsoft.com/office/drawing/2014/main" id="{08C92E7C-3F41-4F84-B25F-C9AB12703433}"/>
                </a:ext>
              </a:extLst>
            </p:cNvPr>
            <p:cNvSpPr/>
            <p:nvPr/>
          </p:nvSpPr>
          <p:spPr>
            <a:xfrm>
              <a:off x="7086600" y="5715000"/>
              <a:ext cx="152400" cy="15240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Oval 33">
              <a:extLst>
                <a:ext uri="{FF2B5EF4-FFF2-40B4-BE49-F238E27FC236}">
                  <a16:creationId xmlns:a16="http://schemas.microsoft.com/office/drawing/2014/main" id="{36E3E81D-3458-4773-83E9-8F97441562F3}"/>
                </a:ext>
              </a:extLst>
            </p:cNvPr>
            <p:cNvSpPr/>
            <p:nvPr/>
          </p:nvSpPr>
          <p:spPr>
            <a:xfrm>
              <a:off x="7239000" y="5867400"/>
              <a:ext cx="152400" cy="15240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Oval 34">
              <a:extLst>
                <a:ext uri="{FF2B5EF4-FFF2-40B4-BE49-F238E27FC236}">
                  <a16:creationId xmlns:a16="http://schemas.microsoft.com/office/drawing/2014/main" id="{595EA997-0244-435E-AA74-24BA860DAD64}"/>
                </a:ext>
              </a:extLst>
            </p:cNvPr>
            <p:cNvSpPr/>
            <p:nvPr/>
          </p:nvSpPr>
          <p:spPr>
            <a:xfrm>
              <a:off x="7391400" y="6019800"/>
              <a:ext cx="152400" cy="15240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" name="Oval 35">
              <a:extLst>
                <a:ext uri="{FF2B5EF4-FFF2-40B4-BE49-F238E27FC236}">
                  <a16:creationId xmlns:a16="http://schemas.microsoft.com/office/drawing/2014/main" id="{BDD02E9C-F8B7-4A4A-A3FC-DCD5AB4C2622}"/>
                </a:ext>
              </a:extLst>
            </p:cNvPr>
            <p:cNvSpPr/>
            <p:nvPr/>
          </p:nvSpPr>
          <p:spPr>
            <a:xfrm>
              <a:off x="7301547" y="5694482"/>
              <a:ext cx="152400" cy="15240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" name="Oval 36">
              <a:extLst>
                <a:ext uri="{FF2B5EF4-FFF2-40B4-BE49-F238E27FC236}">
                  <a16:creationId xmlns:a16="http://schemas.microsoft.com/office/drawing/2014/main" id="{6519DF70-DDDD-4A9A-8C25-8FA520A655D9}"/>
                </a:ext>
              </a:extLst>
            </p:cNvPr>
            <p:cNvSpPr/>
            <p:nvPr/>
          </p:nvSpPr>
          <p:spPr>
            <a:xfrm>
              <a:off x="7453947" y="5846882"/>
              <a:ext cx="152400" cy="15240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Freeform: Shape 37">
              <a:extLst>
                <a:ext uri="{FF2B5EF4-FFF2-40B4-BE49-F238E27FC236}">
                  <a16:creationId xmlns:a16="http://schemas.microsoft.com/office/drawing/2014/main" id="{E693FF8C-47AF-4AD0-B036-15C05F0967D3}"/>
                </a:ext>
              </a:extLst>
            </p:cNvPr>
            <p:cNvSpPr/>
            <p:nvPr/>
          </p:nvSpPr>
          <p:spPr>
            <a:xfrm>
              <a:off x="6182139" y="5436592"/>
              <a:ext cx="983974" cy="268469"/>
            </a:xfrm>
            <a:custGeom>
              <a:avLst/>
              <a:gdLst>
                <a:gd name="connsiteX0" fmla="*/ 983974 w 983974"/>
                <a:gd name="connsiteY0" fmla="*/ 228712 h 268469"/>
                <a:gd name="connsiteX1" fmla="*/ 795131 w 983974"/>
                <a:gd name="connsiteY1" fmla="*/ 69686 h 268469"/>
                <a:gd name="connsiteX2" fmla="*/ 327991 w 983974"/>
                <a:gd name="connsiteY2" fmla="*/ 10051 h 268469"/>
                <a:gd name="connsiteX3" fmla="*/ 0 w 983974"/>
                <a:gd name="connsiteY3" fmla="*/ 268469 h 2684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983974" h="268469">
                  <a:moveTo>
                    <a:pt x="983974" y="228712"/>
                  </a:moveTo>
                  <a:cubicBezTo>
                    <a:pt x="944217" y="167420"/>
                    <a:pt x="904461" y="106129"/>
                    <a:pt x="795131" y="69686"/>
                  </a:cubicBezTo>
                  <a:cubicBezTo>
                    <a:pt x="685801" y="33243"/>
                    <a:pt x="460513" y="-23079"/>
                    <a:pt x="327991" y="10051"/>
                  </a:cubicBezTo>
                  <a:cubicBezTo>
                    <a:pt x="195469" y="43181"/>
                    <a:pt x="97734" y="155825"/>
                    <a:pt x="0" y="268469"/>
                  </a:cubicBezTo>
                </a:path>
              </a:pathLst>
            </a:custGeom>
            <a:noFill/>
            <a:ln>
              <a:headEnd type="none" w="med" len="med"/>
              <a:tailEnd type="triangle" w="med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Freeform: Shape 38">
              <a:extLst>
                <a:ext uri="{FF2B5EF4-FFF2-40B4-BE49-F238E27FC236}">
                  <a16:creationId xmlns:a16="http://schemas.microsoft.com/office/drawing/2014/main" id="{87704EF9-C2A8-4774-A41A-183C26BE90D6}"/>
                </a:ext>
              </a:extLst>
            </p:cNvPr>
            <p:cNvSpPr/>
            <p:nvPr/>
          </p:nvSpPr>
          <p:spPr>
            <a:xfrm>
              <a:off x="7190579" y="4939748"/>
              <a:ext cx="233951" cy="646043"/>
            </a:xfrm>
            <a:custGeom>
              <a:avLst/>
              <a:gdLst>
                <a:gd name="connsiteX0" fmla="*/ 94804 w 233951"/>
                <a:gd name="connsiteY0" fmla="*/ 646043 h 646043"/>
                <a:gd name="connsiteX1" fmla="*/ 5351 w 233951"/>
                <a:gd name="connsiteY1" fmla="*/ 218661 h 646043"/>
                <a:gd name="connsiteX2" fmla="*/ 233951 w 233951"/>
                <a:gd name="connsiteY2" fmla="*/ 0 h 64604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33951" h="646043">
                  <a:moveTo>
                    <a:pt x="94804" y="646043"/>
                  </a:moveTo>
                  <a:cubicBezTo>
                    <a:pt x="38482" y="486189"/>
                    <a:pt x="-17840" y="326335"/>
                    <a:pt x="5351" y="218661"/>
                  </a:cubicBezTo>
                  <a:cubicBezTo>
                    <a:pt x="28542" y="110987"/>
                    <a:pt x="131246" y="55493"/>
                    <a:pt x="233951" y="0"/>
                  </a:cubicBezTo>
                </a:path>
              </a:pathLst>
            </a:custGeom>
            <a:noFill/>
            <a:ln>
              <a:headEnd type="none" w="med" len="med"/>
              <a:tailEnd type="triangle" w="med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4796420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AFB1C0-CC93-4AC4-B08F-2922D78000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ibrary Preparation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B0ACF8F-D1E6-421D-8930-2D664F0D6BFF}"/>
              </a:ext>
            </a:extLst>
          </p:cNvPr>
          <p:cNvSpPr txBox="1"/>
          <p:nvPr/>
        </p:nvSpPr>
        <p:spPr>
          <a:xfrm>
            <a:off x="1143000" y="1473141"/>
            <a:ext cx="7310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gDNA extraction: overnight lysis + Bead-bashing + Qiagen Tissue &amp; Cells kit)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F73D8A6A-6ECA-49F5-A244-7590412D145F}"/>
              </a:ext>
            </a:extLst>
          </p:cNvPr>
          <p:cNvGrpSpPr/>
          <p:nvPr/>
        </p:nvGrpSpPr>
        <p:grpSpPr>
          <a:xfrm>
            <a:off x="1676400" y="2153106"/>
            <a:ext cx="5791200" cy="3748564"/>
            <a:chOff x="1676400" y="2153106"/>
            <a:chExt cx="5791200" cy="3748564"/>
          </a:xfrm>
        </p:grpSpPr>
        <p:cxnSp>
          <p:nvCxnSpPr>
            <p:cNvPr id="4" name="Straight Arrow Connector 3">
              <a:extLst>
                <a:ext uri="{FF2B5EF4-FFF2-40B4-BE49-F238E27FC236}">
                  <a16:creationId xmlns:a16="http://schemas.microsoft.com/office/drawing/2014/main" id="{E1B2E0E5-6067-4181-8D9C-BB88E75385E2}"/>
                </a:ext>
              </a:extLst>
            </p:cNvPr>
            <p:cNvCxnSpPr/>
            <p:nvPr/>
          </p:nvCxnSpPr>
          <p:spPr>
            <a:xfrm>
              <a:off x="3086100" y="2928838"/>
              <a:ext cx="838200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077EFE2E-9D39-4408-AE47-0306C811FCC6}"/>
                </a:ext>
              </a:extLst>
            </p:cNvPr>
            <p:cNvCxnSpPr/>
            <p:nvPr/>
          </p:nvCxnSpPr>
          <p:spPr>
            <a:xfrm flipH="1">
              <a:off x="5410200" y="2928838"/>
              <a:ext cx="838200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25519FE0-59AA-4925-8401-C2EE94D2D8A3}"/>
                </a:ext>
              </a:extLst>
            </p:cNvPr>
            <p:cNvCxnSpPr/>
            <p:nvPr/>
          </p:nvCxnSpPr>
          <p:spPr>
            <a:xfrm flipH="1" flipV="1">
              <a:off x="2705100" y="2547838"/>
              <a:ext cx="381000" cy="381000"/>
            </a:xfrm>
            <a:prstGeom prst="line">
              <a:avLst/>
            </a:prstGeom>
            <a:ln w="571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1F9E7F12-B16D-4CA4-8805-8D6BCCB1D737}"/>
                </a:ext>
              </a:extLst>
            </p:cNvPr>
            <p:cNvCxnSpPr/>
            <p:nvPr/>
          </p:nvCxnSpPr>
          <p:spPr>
            <a:xfrm flipV="1">
              <a:off x="6221186" y="2547838"/>
              <a:ext cx="381000" cy="381000"/>
            </a:xfrm>
            <a:prstGeom prst="line">
              <a:avLst/>
            </a:prstGeom>
            <a:ln w="57150">
              <a:solidFill>
                <a:schemeClr val="accent3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D11CD855-4552-4A16-A096-5D66D300BAF1}"/>
                </a:ext>
              </a:extLst>
            </p:cNvPr>
            <p:cNvCxnSpPr/>
            <p:nvPr/>
          </p:nvCxnSpPr>
          <p:spPr>
            <a:xfrm>
              <a:off x="2514600" y="4224238"/>
              <a:ext cx="800100" cy="0"/>
            </a:xfrm>
            <a:prstGeom prst="line">
              <a:avLst/>
            </a:prstGeom>
            <a:ln w="571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0C4617EF-9E35-48FE-9F34-CED5ECE4CD8B}"/>
                </a:ext>
              </a:extLst>
            </p:cNvPr>
            <p:cNvCxnSpPr/>
            <p:nvPr/>
          </p:nvCxnSpPr>
          <p:spPr>
            <a:xfrm>
              <a:off x="5715000" y="4224238"/>
              <a:ext cx="800100" cy="0"/>
            </a:xfrm>
            <a:prstGeom prst="line">
              <a:avLst/>
            </a:prstGeom>
            <a:ln w="57150">
              <a:solidFill>
                <a:schemeClr val="accent3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4AA79785-2918-4F90-B8DA-73BC8F7533DE}"/>
                </a:ext>
              </a:extLst>
            </p:cNvPr>
            <p:cNvCxnSpPr/>
            <p:nvPr/>
          </p:nvCxnSpPr>
          <p:spPr>
            <a:xfrm>
              <a:off x="3314700" y="4224238"/>
              <a:ext cx="800100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AD5E15F5-BE3E-40E2-8E0C-7419C9DD8F8B}"/>
                </a:ext>
              </a:extLst>
            </p:cNvPr>
            <p:cNvCxnSpPr/>
            <p:nvPr/>
          </p:nvCxnSpPr>
          <p:spPr>
            <a:xfrm>
              <a:off x="5029200" y="4224238"/>
              <a:ext cx="723900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FEB82EFC-F0F3-4364-BDF6-B9D075070537}"/>
                </a:ext>
              </a:extLst>
            </p:cNvPr>
            <p:cNvCxnSpPr/>
            <p:nvPr/>
          </p:nvCxnSpPr>
          <p:spPr>
            <a:xfrm>
              <a:off x="4114800" y="4224238"/>
              <a:ext cx="952500" cy="0"/>
            </a:xfrm>
            <a:prstGeom prst="line">
              <a:avLst/>
            </a:prstGeom>
            <a:ln w="571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FB9CB46D-5B88-4816-9569-1224289F62D3}"/>
                </a:ext>
              </a:extLst>
            </p:cNvPr>
            <p:cNvCxnSpPr/>
            <p:nvPr/>
          </p:nvCxnSpPr>
          <p:spPr>
            <a:xfrm>
              <a:off x="2514600" y="3995638"/>
              <a:ext cx="800100" cy="0"/>
            </a:xfrm>
            <a:prstGeom prst="straightConnector1">
              <a:avLst/>
            </a:prstGeom>
            <a:ln w="5715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6E6608E0-895B-4098-A1C8-D297F52FC37B}"/>
                </a:ext>
              </a:extLst>
            </p:cNvPr>
            <p:cNvCxnSpPr/>
            <p:nvPr/>
          </p:nvCxnSpPr>
          <p:spPr>
            <a:xfrm flipH="1">
              <a:off x="2362200" y="3995638"/>
              <a:ext cx="152400" cy="0"/>
            </a:xfrm>
            <a:prstGeom prst="line">
              <a:avLst/>
            </a:prstGeom>
            <a:ln w="571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0CB7F53E-5BCB-49BB-945F-EFBCBB4D52F3}"/>
                </a:ext>
              </a:extLst>
            </p:cNvPr>
            <p:cNvCxnSpPr/>
            <p:nvPr/>
          </p:nvCxnSpPr>
          <p:spPr>
            <a:xfrm flipH="1">
              <a:off x="1676400" y="3995638"/>
              <a:ext cx="685800" cy="0"/>
            </a:xfrm>
            <a:prstGeom prst="line">
              <a:avLst/>
            </a:prstGeom>
            <a:ln w="57150">
              <a:solidFill>
                <a:schemeClr val="accent4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5A56155F-A6DB-44A0-97F9-FC4A035DD762}"/>
                </a:ext>
              </a:extLst>
            </p:cNvPr>
            <p:cNvGrpSpPr/>
            <p:nvPr/>
          </p:nvGrpSpPr>
          <p:grpSpPr>
            <a:xfrm flipH="1">
              <a:off x="5715000" y="4071838"/>
              <a:ext cx="1638300" cy="0"/>
              <a:chOff x="533400" y="2590800"/>
              <a:chExt cx="1638300" cy="0"/>
            </a:xfrm>
          </p:grpSpPr>
          <p:cxnSp>
            <p:nvCxnSpPr>
              <p:cNvPr id="43" name="Straight Arrow Connector 42">
                <a:extLst>
                  <a:ext uri="{FF2B5EF4-FFF2-40B4-BE49-F238E27FC236}">
                    <a16:creationId xmlns:a16="http://schemas.microsoft.com/office/drawing/2014/main" id="{55F25578-DB4E-4757-8329-B55FCCCC809A}"/>
                  </a:ext>
                </a:extLst>
              </p:cNvPr>
              <p:cNvCxnSpPr/>
              <p:nvPr/>
            </p:nvCxnSpPr>
            <p:spPr>
              <a:xfrm>
                <a:off x="1371600" y="2590800"/>
                <a:ext cx="800100" cy="0"/>
              </a:xfrm>
              <a:prstGeom prst="straightConnector1">
                <a:avLst/>
              </a:prstGeom>
              <a:ln w="57150">
                <a:solidFill>
                  <a:schemeClr val="accent3">
                    <a:lumMod val="75000"/>
                  </a:schemeClr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Connector 43">
                <a:extLst>
                  <a:ext uri="{FF2B5EF4-FFF2-40B4-BE49-F238E27FC236}">
                    <a16:creationId xmlns:a16="http://schemas.microsoft.com/office/drawing/2014/main" id="{C0A9DC17-C22D-4C32-8165-F80FC42BF25C}"/>
                  </a:ext>
                </a:extLst>
              </p:cNvPr>
              <p:cNvCxnSpPr/>
              <p:nvPr/>
            </p:nvCxnSpPr>
            <p:spPr>
              <a:xfrm flipH="1">
                <a:off x="1219200" y="2590800"/>
                <a:ext cx="152400" cy="0"/>
              </a:xfrm>
              <a:prstGeom prst="line">
                <a:avLst/>
              </a:prstGeom>
              <a:ln w="571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44">
                <a:extLst>
                  <a:ext uri="{FF2B5EF4-FFF2-40B4-BE49-F238E27FC236}">
                    <a16:creationId xmlns:a16="http://schemas.microsoft.com/office/drawing/2014/main" id="{89E9CDD2-E215-4AD7-8557-B14D3F601BB1}"/>
                  </a:ext>
                </a:extLst>
              </p:cNvPr>
              <p:cNvCxnSpPr/>
              <p:nvPr/>
            </p:nvCxnSpPr>
            <p:spPr>
              <a:xfrm flipH="1">
                <a:off x="533400" y="2590800"/>
                <a:ext cx="685800" cy="0"/>
              </a:xfrm>
              <a:prstGeom prst="line">
                <a:avLst/>
              </a:prstGeom>
              <a:ln w="571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C2E21323-08B9-45F3-8FC0-A7160C682B98}"/>
                </a:ext>
              </a:extLst>
            </p:cNvPr>
            <p:cNvCxnSpPr/>
            <p:nvPr/>
          </p:nvCxnSpPr>
          <p:spPr>
            <a:xfrm>
              <a:off x="2628900" y="5382171"/>
              <a:ext cx="800100" cy="0"/>
            </a:xfrm>
            <a:prstGeom prst="line">
              <a:avLst/>
            </a:prstGeom>
            <a:ln w="571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573FDA05-E3A9-4C81-9672-93E5CCBD8408}"/>
                </a:ext>
              </a:extLst>
            </p:cNvPr>
            <p:cNvCxnSpPr/>
            <p:nvPr/>
          </p:nvCxnSpPr>
          <p:spPr>
            <a:xfrm>
              <a:off x="5829300" y="5382171"/>
              <a:ext cx="800100" cy="0"/>
            </a:xfrm>
            <a:prstGeom prst="line">
              <a:avLst/>
            </a:prstGeom>
            <a:ln w="57150">
              <a:solidFill>
                <a:schemeClr val="accent3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0DB1BACA-8A62-4FAE-893C-86B0C2CBD87B}"/>
                </a:ext>
              </a:extLst>
            </p:cNvPr>
            <p:cNvCxnSpPr/>
            <p:nvPr/>
          </p:nvCxnSpPr>
          <p:spPr>
            <a:xfrm>
              <a:off x="3429000" y="5382171"/>
              <a:ext cx="800100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67867B5E-A5B7-4224-984D-CB647BD9E277}"/>
                </a:ext>
              </a:extLst>
            </p:cNvPr>
            <p:cNvCxnSpPr/>
            <p:nvPr/>
          </p:nvCxnSpPr>
          <p:spPr>
            <a:xfrm>
              <a:off x="5143500" y="5382171"/>
              <a:ext cx="723900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1FAA0C3E-9682-45E0-8C6D-D61BEE5CBBD7}"/>
                </a:ext>
              </a:extLst>
            </p:cNvPr>
            <p:cNvCxnSpPr/>
            <p:nvPr/>
          </p:nvCxnSpPr>
          <p:spPr>
            <a:xfrm>
              <a:off x="4229100" y="5382171"/>
              <a:ext cx="952500" cy="0"/>
            </a:xfrm>
            <a:prstGeom prst="line">
              <a:avLst/>
            </a:prstGeom>
            <a:ln w="571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48676A7B-0672-45CF-8D2F-A1FA99DFC31F}"/>
                </a:ext>
              </a:extLst>
            </p:cNvPr>
            <p:cNvCxnSpPr/>
            <p:nvPr/>
          </p:nvCxnSpPr>
          <p:spPr>
            <a:xfrm flipH="1">
              <a:off x="2476500" y="5382171"/>
              <a:ext cx="152400" cy="0"/>
            </a:xfrm>
            <a:prstGeom prst="line">
              <a:avLst/>
            </a:prstGeom>
            <a:ln w="571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937C1B0B-5D48-4201-ABA5-88C794CB2FED}"/>
                </a:ext>
              </a:extLst>
            </p:cNvPr>
            <p:cNvCxnSpPr/>
            <p:nvPr/>
          </p:nvCxnSpPr>
          <p:spPr>
            <a:xfrm flipH="1">
              <a:off x="1790700" y="5382171"/>
              <a:ext cx="685800" cy="0"/>
            </a:xfrm>
            <a:prstGeom prst="line">
              <a:avLst/>
            </a:prstGeom>
            <a:ln w="57150">
              <a:solidFill>
                <a:schemeClr val="accent4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63186C57-A78E-4784-956D-E4965FB9B63A}"/>
                </a:ext>
              </a:extLst>
            </p:cNvPr>
            <p:cNvCxnSpPr/>
            <p:nvPr/>
          </p:nvCxnSpPr>
          <p:spPr>
            <a:xfrm>
              <a:off x="6629400" y="5382171"/>
              <a:ext cx="152400" cy="0"/>
            </a:xfrm>
            <a:prstGeom prst="line">
              <a:avLst/>
            </a:prstGeom>
            <a:ln w="571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EC3301B0-9448-409B-BD84-C2876062EDF1}"/>
                </a:ext>
              </a:extLst>
            </p:cNvPr>
            <p:cNvCxnSpPr/>
            <p:nvPr/>
          </p:nvCxnSpPr>
          <p:spPr>
            <a:xfrm>
              <a:off x="6781800" y="5382171"/>
              <a:ext cx="685800" cy="0"/>
            </a:xfrm>
            <a:prstGeom prst="line">
              <a:avLst/>
            </a:prstGeom>
            <a:ln w="571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Arrow Connector 25">
              <a:extLst>
                <a:ext uri="{FF2B5EF4-FFF2-40B4-BE49-F238E27FC236}">
                  <a16:creationId xmlns:a16="http://schemas.microsoft.com/office/drawing/2014/main" id="{233BA810-DADE-450B-806F-3A88396D5F42}"/>
                </a:ext>
              </a:extLst>
            </p:cNvPr>
            <p:cNvCxnSpPr/>
            <p:nvPr/>
          </p:nvCxnSpPr>
          <p:spPr>
            <a:xfrm>
              <a:off x="3429000" y="5610771"/>
              <a:ext cx="201978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oval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Arrow Connector 26">
              <a:extLst>
                <a:ext uri="{FF2B5EF4-FFF2-40B4-BE49-F238E27FC236}">
                  <a16:creationId xmlns:a16="http://schemas.microsoft.com/office/drawing/2014/main" id="{67DFC0CB-DCAB-4BA4-86AA-A5B048B6C407}"/>
                </a:ext>
              </a:extLst>
            </p:cNvPr>
            <p:cNvCxnSpPr/>
            <p:nvPr/>
          </p:nvCxnSpPr>
          <p:spPr>
            <a:xfrm flipH="1">
              <a:off x="4036671" y="5763171"/>
              <a:ext cx="1868829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oval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E63E5D8-1787-412B-A06F-274F75EC159C}"/>
                </a:ext>
              </a:extLst>
            </p:cNvPr>
            <p:cNvSpPr txBox="1"/>
            <p:nvPr/>
          </p:nvSpPr>
          <p:spPr>
            <a:xfrm>
              <a:off x="2705100" y="5479891"/>
              <a:ext cx="609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Read 1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A346C862-766A-464D-9488-464B3CC4A490}"/>
                </a:ext>
              </a:extLst>
            </p:cNvPr>
            <p:cNvSpPr txBox="1"/>
            <p:nvPr/>
          </p:nvSpPr>
          <p:spPr>
            <a:xfrm>
              <a:off x="5981325" y="5624671"/>
              <a:ext cx="60997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Read 2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A439ACF3-F939-4E09-97BD-C5CA02082FA5}"/>
                </a:ext>
              </a:extLst>
            </p:cNvPr>
            <p:cNvSpPr txBox="1"/>
            <p:nvPr/>
          </p:nvSpPr>
          <p:spPr>
            <a:xfrm>
              <a:off x="3115487" y="2153106"/>
              <a:ext cx="28412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. Adapter-loci amplification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0DC0B665-130F-4359-9529-85B67326581F}"/>
                </a:ext>
              </a:extLst>
            </p:cNvPr>
            <p:cNvSpPr txBox="1"/>
            <p:nvPr/>
          </p:nvSpPr>
          <p:spPr>
            <a:xfrm>
              <a:off x="3354302" y="3462238"/>
              <a:ext cx="248548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. Indexing amplification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27E01BA5-6117-4412-9434-E310410CDFE1}"/>
                </a:ext>
              </a:extLst>
            </p:cNvPr>
            <p:cNvSpPr txBox="1"/>
            <p:nvPr/>
          </p:nvSpPr>
          <p:spPr>
            <a:xfrm>
              <a:off x="3423103" y="4605238"/>
              <a:ext cx="23478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Final library fragments: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5D59D5E7-E810-460C-859F-C75811893507}"/>
                </a:ext>
              </a:extLst>
            </p:cNvPr>
            <p:cNvSpPr txBox="1"/>
            <p:nvPr/>
          </p:nvSpPr>
          <p:spPr>
            <a:xfrm>
              <a:off x="1721252" y="3659105"/>
              <a:ext cx="609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5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24C213D8-609C-46AF-9C73-BE8C9E77F1C4}"/>
                </a:ext>
              </a:extLst>
            </p:cNvPr>
            <p:cNvSpPr txBox="1"/>
            <p:nvPr/>
          </p:nvSpPr>
          <p:spPr>
            <a:xfrm>
              <a:off x="2140352" y="3659105"/>
              <a:ext cx="609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Index1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B2EB2475-AD8B-4A78-A808-C63B34150275}"/>
                </a:ext>
              </a:extLst>
            </p:cNvPr>
            <p:cNvSpPr txBox="1"/>
            <p:nvPr/>
          </p:nvSpPr>
          <p:spPr>
            <a:xfrm>
              <a:off x="1916107" y="2333139"/>
              <a:ext cx="8047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Adapter1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49016AC8-04E6-4B91-AB18-3D740E997462}"/>
                </a:ext>
              </a:extLst>
            </p:cNvPr>
            <p:cNvSpPr txBox="1"/>
            <p:nvPr/>
          </p:nvSpPr>
          <p:spPr>
            <a:xfrm>
              <a:off x="3611645" y="5001768"/>
              <a:ext cx="2095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Amplicon with variable region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7C8FD8FF-5A3A-4BF6-97CE-0DF17FD5738B}"/>
                </a:ext>
              </a:extLst>
            </p:cNvPr>
            <p:cNvSpPr txBox="1"/>
            <p:nvPr/>
          </p:nvSpPr>
          <p:spPr>
            <a:xfrm>
              <a:off x="6619246" y="2306497"/>
              <a:ext cx="7870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Adapter2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76BF97A3-ADE9-4702-B4B9-A9C6950538CE}"/>
                </a:ext>
              </a:extLst>
            </p:cNvPr>
            <p:cNvSpPr txBox="1"/>
            <p:nvPr/>
          </p:nvSpPr>
          <p:spPr>
            <a:xfrm>
              <a:off x="6255152" y="3659105"/>
              <a:ext cx="609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Index2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FCC14C18-779C-4693-B904-96CC635F9C93}"/>
                </a:ext>
              </a:extLst>
            </p:cNvPr>
            <p:cNvSpPr txBox="1"/>
            <p:nvPr/>
          </p:nvSpPr>
          <p:spPr>
            <a:xfrm>
              <a:off x="6940952" y="3659105"/>
              <a:ext cx="4191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7</a:t>
              </a:r>
            </a:p>
          </p:txBody>
        </p: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97052D0A-3FAD-4059-8107-9ABD2995A958}"/>
                </a:ext>
              </a:extLst>
            </p:cNvPr>
            <p:cNvCxnSpPr/>
            <p:nvPr/>
          </p:nvCxnSpPr>
          <p:spPr>
            <a:xfrm>
              <a:off x="2667000" y="3233638"/>
              <a:ext cx="1479196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1F700239-07F8-49DB-B7BA-DAA6A5FD0D40}"/>
                </a:ext>
              </a:extLst>
            </p:cNvPr>
            <p:cNvCxnSpPr/>
            <p:nvPr/>
          </p:nvCxnSpPr>
          <p:spPr>
            <a:xfrm>
              <a:off x="5060596" y="3233638"/>
              <a:ext cx="1619250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616A7890-AA1B-40DC-81F0-2C924EFF9495}"/>
                </a:ext>
              </a:extLst>
            </p:cNvPr>
            <p:cNvCxnSpPr/>
            <p:nvPr/>
          </p:nvCxnSpPr>
          <p:spPr>
            <a:xfrm>
              <a:off x="4146196" y="3233638"/>
              <a:ext cx="952500" cy="0"/>
            </a:xfrm>
            <a:prstGeom prst="line">
              <a:avLst/>
            </a:prstGeom>
            <a:ln w="571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5B932390-B5C8-40C8-ABA9-2DFEDE7475C6}"/>
                </a:ext>
              </a:extLst>
            </p:cNvPr>
            <p:cNvSpPr txBox="1"/>
            <p:nvPr/>
          </p:nvSpPr>
          <p:spPr>
            <a:xfrm>
              <a:off x="3212266" y="2544717"/>
              <a:ext cx="9243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FOR primer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A8A21907-036C-4769-BD53-5BE03F84249F}"/>
                </a:ext>
              </a:extLst>
            </p:cNvPr>
            <p:cNvSpPr txBox="1"/>
            <p:nvPr/>
          </p:nvSpPr>
          <p:spPr>
            <a:xfrm>
              <a:off x="5286514" y="2498238"/>
              <a:ext cx="9243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REV primer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406879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9</TotalTime>
  <Words>135</Words>
  <Application>Microsoft Office PowerPoint</Application>
  <PresentationFormat>On-screen Show (4:3)</PresentationFormat>
  <Paragraphs>3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Sequencing Pipeline</vt:lpstr>
      <vt:lpstr>SpringstarTM blue vane trap</vt:lpstr>
      <vt:lpstr>Tissue Preparation</vt:lpstr>
      <vt:lpstr>Library Prepar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rian Darby</dc:creator>
  <cp:lastModifiedBy>Darby, Brian</cp:lastModifiedBy>
  <cp:revision>22</cp:revision>
  <dcterms:created xsi:type="dcterms:W3CDTF">2016-02-10T16:04:51Z</dcterms:created>
  <dcterms:modified xsi:type="dcterms:W3CDTF">2019-12-16T21:48:31Z</dcterms:modified>
</cp:coreProperties>
</file>